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57" r:id="rId2"/>
    <p:sldId id="259" r:id="rId3"/>
    <p:sldId id="258" r:id="rId4"/>
    <p:sldId id="260" r:id="rId5"/>
    <p:sldId id="261" r:id="rId6"/>
    <p:sldId id="262" r:id="rId7"/>
    <p:sldId id="264" r:id="rId8"/>
    <p:sldId id="263" r:id="rId9"/>
    <p:sldId id="265" r:id="rId10"/>
    <p:sldId id="266" r:id="rId11"/>
    <p:sldId id="267" r:id="rId12"/>
    <p:sldId id="268" r:id="rId13"/>
    <p:sldId id="269" r:id="rId14"/>
    <p:sldId id="270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enkata Dasari" initials="VD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20" autoAdjust="0"/>
    <p:restoredTop sz="94660"/>
  </p:normalViewPr>
  <p:slideViewPr>
    <p:cSldViewPr snapToGrid="0">
      <p:cViewPr>
        <p:scale>
          <a:sx n="81" d="100"/>
          <a:sy n="81" d="100"/>
        </p:scale>
        <p:origin x="-84" y="-7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5.emf"/><Relationship Id="rId2" Type="http://schemas.openxmlformats.org/officeDocument/2006/relationships/image" Target="../media/image54.emf"/><Relationship Id="rId1" Type="http://schemas.openxmlformats.org/officeDocument/2006/relationships/image" Target="../media/image5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7E7F4C-76A1-4717-8BBF-3E369CDEFF37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731DA8-A84A-483F-A2FA-4D0F1B918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9378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F58E235-C9AA-4592-8C48-144B4EACC1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E894AC7B-68F2-4586-BC14-42270DF402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DE3D817-EF0A-44C4-A9F2-C0CF798B3D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1D3F5-459C-4E83-8CBB-2F93F5D71547}" type="datetime1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ADDF0FF-E7A8-4264-BFA5-F22268406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24EDE99-77FE-4658-9E04-CB33B348D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612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6AAC56D-3495-4C56-B777-357C625316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73A784D-2438-4C6D-B66C-1F61AD58FD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52A274A-9DEF-45E4-A742-8D1D30323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DA9A4-D808-4CEA-BB48-0D1FC69994EE}" type="datetime1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AFB00AA-7796-4E03-8C87-01999DF88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84740B1-496E-4DBF-80B5-0D7738290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59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F1FC7600-ECB0-4798-83CE-0E8651CE11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C9486AF-5D74-417C-8A0B-2BBC38C658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3E6F325-E0E5-4949-9DF5-E79240B26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A128E-BB74-42A5-B82F-1ACCAC6D4253}" type="datetime1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79807BB-5DEE-4EB4-B485-AA4E14F0ED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7D87D39-069D-4E70-B33A-39331AF08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147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E92E89D-637E-4A4B-97B9-5A43EE0510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41B1414-C948-4F18-860A-117BADA46B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88218FB-42CF-46D1-AB29-B211AC9E5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FE105-70D2-417B-A08E-0EBD8FC8978E}" type="datetime1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D66A01A-C928-4C64-9527-8252FDD6E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FABF7A4-E308-487B-8352-75089811E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393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104FA48-373C-46FD-ADAC-68F49CFD95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4817135-1FF4-4B9C-9F96-DDB0D91C82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5C41103-B28D-4A28-B896-EACD12BBD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46740-7E37-4E8C-A0EE-CB22871B8A56}" type="datetime1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6BB9A88-4467-41A4-B1B7-2F78F5B65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44FDF60-182F-4B63-9972-6B3657516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876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F23FC7F-998C-4525-8211-215CEADE7E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5220620-C644-41C0-9EA3-7606ACAF0B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DD22BDD-8937-44CE-91DA-BBEE1D75A8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7303905-37E3-43EE-88DD-C8D672D6C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094AC-F4C7-4EC5-82B9-3691A55F5813}" type="datetime1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A3C595B-2E73-43AF-8DB1-E2FAF0B0C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8C746D4-F3CA-4539-9D2B-5EC4DE980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467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F72E9F3-D86D-4E4B-8671-129A36E26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6E68452-F19B-4D48-8E0C-BF9BFC3F83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62E80F5-B35D-47B0-9617-0E87FAC3C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B1FCCB36-4AFA-4BF1-AEB5-04AAF5E59D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0C5E55AC-0D96-42CC-A7B8-F1332DB5A3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C839F052-5FDB-4688-9B5F-F82C99219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AEC50-5090-4401-918E-F1D35633D136}" type="datetime1">
              <a:rPr lang="en-US" smtClean="0"/>
              <a:t>3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FD01CBEB-8893-4966-BCBE-F4F3ABCCC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EDA643B8-EABE-4933-A377-EF825303F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602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A20BF24-75C7-4330-8DE5-26C5E440D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593F3BCC-6464-400C-B30B-2B7B5FF6B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11F15-6BCC-4AAF-AB1C-E7ABBE58984E}" type="datetime1">
              <a:rPr lang="en-US" smtClean="0"/>
              <a:t>3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9833C97E-0B2F-41E8-A853-4EB2781F2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B447A07-47ED-4DF7-994D-647D757B1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215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2B742F81-EA06-4F9C-B522-72CCCF65F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49D1F-8E86-4B22-89F7-826D8718229F}" type="datetime1">
              <a:rPr lang="en-US" smtClean="0"/>
              <a:t>3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B8A645BA-804F-4C59-82D2-D7B4CFC3C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7F329D52-BF51-43D6-8FB9-68E854BF7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47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7C9CC01-4219-4040-9E03-F897894CED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3B88C57-9D89-4655-AF95-691012DBF0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6DE500C-454A-4D41-86A5-6D281FA1C5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3680D2B-A32B-4700-978F-6F549D96A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2F923-807E-4FAA-AC21-600504784901}" type="datetime1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2FECE02-0926-47A9-9F9B-9E7ED28C0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81CB876-72A8-4EF4-A3FF-103B9334F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878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561C743-F28F-47B2-B0D2-C18AC009D0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DC05CA40-EE19-4CAB-9369-FE788A11CA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1050501-C5DD-4993-AB29-64133AEB0B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5CA3F71-5AC3-4A3E-8A0B-28182A467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0C19-4A2C-4474-BB87-413234C676E0}" type="datetime1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C1695D8-AC81-4734-9CC9-561896341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C92BF27-AB3C-4300-AAEB-306F0A7CF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871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3A2C4565-AAC0-4B91-8F3E-70074AACD3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FC492AB-CDDB-4AAB-B087-C2B0239CC6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86DECF5-E7A2-4D0E-BC5E-C8563BA60F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C1027-480A-4530-A887-E115C7ABA04E}" type="datetime1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3A03521-B6AE-4DE0-B004-69F99D6C01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8CDA24C-ABFD-451F-843A-6B3BEC83C7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19523C-807E-43F0-B269-3AFA6A5C2B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406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gif"/><Relationship Id="rId2" Type="http://schemas.openxmlformats.org/officeDocument/2006/relationships/image" Target="../media/image44.g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6.gi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gif"/><Relationship Id="rId2" Type="http://schemas.openxmlformats.org/officeDocument/2006/relationships/image" Target="../media/image47.g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9.gi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gif"/><Relationship Id="rId2" Type="http://schemas.openxmlformats.org/officeDocument/2006/relationships/image" Target="../media/image50.g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2.gi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emf"/><Relationship Id="rId3" Type="http://schemas.openxmlformats.org/officeDocument/2006/relationships/package" Target="../embeddings/Microsoft_Excel_Worksheet1.xlsx"/><Relationship Id="rId7" Type="http://schemas.openxmlformats.org/officeDocument/2006/relationships/package" Target="../embeddings/Microsoft_Excel_Worksheet3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4.emf"/><Relationship Id="rId5" Type="http://schemas.openxmlformats.org/officeDocument/2006/relationships/package" Target="../embeddings/Microsoft_Excel_Worksheet2.xlsx"/><Relationship Id="rId4" Type="http://schemas.openxmlformats.org/officeDocument/2006/relationships/image" Target="../media/image53.em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png"/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png"/><Relationship Id="rId11" Type="http://schemas.openxmlformats.org/officeDocument/2006/relationships/image" Target="../media/image65.png"/><Relationship Id="rId5" Type="http://schemas.openxmlformats.org/officeDocument/2006/relationships/image" Target="../media/image59.png"/><Relationship Id="rId10" Type="http://schemas.openxmlformats.org/officeDocument/2006/relationships/image" Target="../media/image64.png"/><Relationship Id="rId4" Type="http://schemas.openxmlformats.org/officeDocument/2006/relationships/image" Target="../media/image58.png"/><Relationship Id="rId9" Type="http://schemas.openxmlformats.org/officeDocument/2006/relationships/image" Target="../media/image6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gif"/><Relationship Id="rId7" Type="http://schemas.openxmlformats.org/officeDocument/2006/relationships/image" Target="../media/image18.gif"/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gif"/><Relationship Id="rId5" Type="http://schemas.openxmlformats.org/officeDocument/2006/relationships/image" Target="../media/image16.gif"/><Relationship Id="rId4" Type="http://schemas.openxmlformats.org/officeDocument/2006/relationships/image" Target="../media/image15.g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gif"/><Relationship Id="rId7" Type="http://schemas.openxmlformats.org/officeDocument/2006/relationships/image" Target="../media/image24.gif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gif"/><Relationship Id="rId5" Type="http://schemas.openxmlformats.org/officeDocument/2006/relationships/image" Target="../media/image22.gif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gif"/><Relationship Id="rId2" Type="http://schemas.openxmlformats.org/officeDocument/2006/relationships/image" Target="../media/image33.g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gif"/><Relationship Id="rId4" Type="http://schemas.openxmlformats.org/officeDocument/2006/relationships/image" Target="../media/image35.g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gif"/><Relationship Id="rId2" Type="http://schemas.openxmlformats.org/officeDocument/2006/relationships/image" Target="../media/image37.g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0.gif"/><Relationship Id="rId4" Type="http://schemas.openxmlformats.org/officeDocument/2006/relationships/image" Target="../media/image39.gi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gif"/><Relationship Id="rId2" Type="http://schemas.openxmlformats.org/officeDocument/2006/relationships/image" Target="../media/image41.g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>
            <a:extLst>
              <a:ext uri="{FF2B5EF4-FFF2-40B4-BE49-F238E27FC236}">
                <a16:creationId xmlns:a16="http://schemas.microsoft.com/office/drawing/2014/main" xmlns="" id="{9685CA1A-ADF3-4111-93E3-A996D9857488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44043" y="400050"/>
            <a:ext cx="3840480" cy="32004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CA94AC1C-9840-442A-A69A-41A347292335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230243" y="400050"/>
            <a:ext cx="3840480" cy="3200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429F5386-BCB1-49AA-8473-581E03CCBECE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230243" y="3362652"/>
            <a:ext cx="3840480" cy="32004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BFC255DD-1CFB-427B-9185-52C8E59DA42A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44043" y="3362652"/>
            <a:ext cx="3840480" cy="3200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496BD01C-38C6-4CAF-B073-4B10D2B37F4F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8031480" y="3362652"/>
            <a:ext cx="3840480" cy="3200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00690F8F-A1F9-4A93-A10E-F55C1D0532C1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8031480" y="400050"/>
            <a:ext cx="3840480" cy="3200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868A3BD5-346A-4704-8963-51FAA15C573B}"/>
              </a:ext>
            </a:extLst>
          </p:cNvPr>
          <p:cNvSpPr txBox="1"/>
          <p:nvPr/>
        </p:nvSpPr>
        <p:spPr>
          <a:xfrm>
            <a:off x="5032898" y="30718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S1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xmlns="" id="{0FA760CD-1655-469B-BEA6-A7F722570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1386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6473D058-9771-48B3-93D1-19E6F86F671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419"/>
          <a:stretch/>
        </p:blipFill>
        <p:spPr>
          <a:xfrm>
            <a:off x="571867" y="1539386"/>
            <a:ext cx="3658490" cy="33337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CA01B82-C14D-485D-93EE-1E3BAABA048A}"/>
              </a:ext>
            </a:extLst>
          </p:cNvPr>
          <p:cNvSpPr txBox="1"/>
          <p:nvPr/>
        </p:nvSpPr>
        <p:spPr>
          <a:xfrm>
            <a:off x="2131024" y="1713393"/>
            <a:ext cx="699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V9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1343227-3A66-442A-B12C-FB816EF184EF}"/>
              </a:ext>
            </a:extLst>
          </p:cNvPr>
          <p:cNvSpPr txBox="1"/>
          <p:nvPr/>
        </p:nvSpPr>
        <p:spPr>
          <a:xfrm>
            <a:off x="2830639" y="3206261"/>
            <a:ext cx="9827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ynergisti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081AE3C8-BC8D-4A39-93C3-34B80C653463}"/>
              </a:ext>
            </a:extLst>
          </p:cNvPr>
          <p:cNvSpPr txBox="1"/>
          <p:nvPr/>
        </p:nvSpPr>
        <p:spPr>
          <a:xfrm>
            <a:off x="2658640" y="2770170"/>
            <a:ext cx="11104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ntagonistic</a:t>
            </a:r>
          </a:p>
        </p:txBody>
      </p:sp>
      <p:pic>
        <p:nvPicPr>
          <p:cNvPr id="8" name="Picture 7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xmlns="" id="{E7BA211F-2962-4D2C-94D9-7E5994FDA00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419"/>
          <a:stretch/>
        </p:blipFill>
        <p:spPr>
          <a:xfrm>
            <a:off x="4230358" y="1539386"/>
            <a:ext cx="3658490" cy="333375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DB047DDA-84FC-496F-9B56-2A7EFE7DE0F1}"/>
              </a:ext>
            </a:extLst>
          </p:cNvPr>
          <p:cNvSpPr txBox="1"/>
          <p:nvPr/>
        </p:nvSpPr>
        <p:spPr>
          <a:xfrm>
            <a:off x="4774277" y="1810224"/>
            <a:ext cx="9380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V50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52A6487F-9804-4336-85C1-F5EDCF6F28F6}"/>
              </a:ext>
            </a:extLst>
          </p:cNvPr>
          <p:cNvSpPr txBox="1"/>
          <p:nvPr/>
        </p:nvSpPr>
        <p:spPr>
          <a:xfrm>
            <a:off x="5022856" y="3207936"/>
            <a:ext cx="9827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ynergisti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B4E65B37-D027-46C3-8EA6-E79C8B96DED2}"/>
              </a:ext>
            </a:extLst>
          </p:cNvPr>
          <p:cNvSpPr txBox="1"/>
          <p:nvPr/>
        </p:nvSpPr>
        <p:spPr>
          <a:xfrm>
            <a:off x="4850857" y="2771845"/>
            <a:ext cx="11104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ntagonistic</a:t>
            </a:r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xmlns="" id="{A9540DB6-9A64-42AF-B732-A040D4965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1F32F-4605-40C6-88EA-D0BD97672771}" type="slidenum">
              <a:rPr lang="en-US" smtClean="0"/>
              <a:t>10</a:t>
            </a:fld>
            <a:endParaRPr lang="en-US"/>
          </a:p>
        </p:txBody>
      </p:sp>
      <p:pic>
        <p:nvPicPr>
          <p:cNvPr id="15" name="Picture 14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0F25E9E8-0BE0-4739-B493-46B02718F27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419"/>
          <a:stretch/>
        </p:blipFill>
        <p:spPr>
          <a:xfrm>
            <a:off x="7909294" y="1539386"/>
            <a:ext cx="3658491" cy="333375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DFD09236-77AD-49BA-8ADD-7530B6778AF8}"/>
              </a:ext>
            </a:extLst>
          </p:cNvPr>
          <p:cNvSpPr txBox="1"/>
          <p:nvPr/>
        </p:nvSpPr>
        <p:spPr>
          <a:xfrm>
            <a:off x="8561553" y="3199563"/>
            <a:ext cx="9827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ynergisti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F3C233E-06C5-403E-A0F7-32023BE6A7BC}"/>
              </a:ext>
            </a:extLst>
          </p:cNvPr>
          <p:cNvSpPr txBox="1"/>
          <p:nvPr/>
        </p:nvSpPr>
        <p:spPr>
          <a:xfrm>
            <a:off x="8389554" y="2763472"/>
            <a:ext cx="11104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ntagonisti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5824D7B1-F646-441B-A664-419BDF38A4F8}"/>
              </a:ext>
            </a:extLst>
          </p:cNvPr>
          <p:cNvSpPr txBox="1"/>
          <p:nvPr/>
        </p:nvSpPr>
        <p:spPr>
          <a:xfrm>
            <a:off x="8389554" y="1903958"/>
            <a:ext cx="1051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2780Ci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5C0D142D-19EE-4B2E-A69A-EB429AAC660E}"/>
              </a:ext>
            </a:extLst>
          </p:cNvPr>
          <p:cNvSpPr txBox="1"/>
          <p:nvPr/>
        </p:nvSpPr>
        <p:spPr>
          <a:xfrm>
            <a:off x="4325295" y="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C2D7D151-B6EF-45D8-ADFF-535B105A5686}"/>
              </a:ext>
            </a:extLst>
          </p:cNvPr>
          <p:cNvSpPr txBox="1"/>
          <p:nvPr/>
        </p:nvSpPr>
        <p:spPr>
          <a:xfrm>
            <a:off x="327356" y="100483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814074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867D91DC-5430-4361-B05E-E18F39F2ADF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41"/>
          <a:stretch/>
        </p:blipFill>
        <p:spPr>
          <a:xfrm>
            <a:off x="558469" y="763343"/>
            <a:ext cx="3681935" cy="33337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8C37493B-6651-4D99-9147-DAF8D42B880F}"/>
              </a:ext>
            </a:extLst>
          </p:cNvPr>
          <p:cNvSpPr txBox="1"/>
          <p:nvPr/>
        </p:nvSpPr>
        <p:spPr>
          <a:xfrm>
            <a:off x="1451668" y="2880515"/>
            <a:ext cx="9827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ynergisti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ECD124A-8FD1-48CE-BFF2-F91C8856982F}"/>
              </a:ext>
            </a:extLst>
          </p:cNvPr>
          <p:cNvSpPr txBox="1"/>
          <p:nvPr/>
        </p:nvSpPr>
        <p:spPr>
          <a:xfrm>
            <a:off x="1387773" y="1971716"/>
            <a:ext cx="11104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ntagonisti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177DB402-F311-4537-BD77-BCFC5B36A946}"/>
              </a:ext>
            </a:extLst>
          </p:cNvPr>
          <p:cNvSpPr txBox="1"/>
          <p:nvPr/>
        </p:nvSpPr>
        <p:spPr>
          <a:xfrm>
            <a:off x="1451668" y="998198"/>
            <a:ext cx="699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V90</a:t>
            </a:r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xmlns="" id="{E9864540-ED4C-4B0D-9E42-C0B5CA14D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1F32F-4605-40C6-88EA-D0BD97672771}" type="slidenum">
              <a:rPr lang="en-US" smtClean="0"/>
              <a:t>11</a:t>
            </a:fld>
            <a:endParaRPr lang="en-US"/>
          </a:p>
        </p:txBody>
      </p:sp>
      <p:pic>
        <p:nvPicPr>
          <p:cNvPr id="13" name="Picture 12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85DA0181-9765-402E-8176-D46C63CE000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41"/>
          <a:stretch/>
        </p:blipFill>
        <p:spPr>
          <a:xfrm>
            <a:off x="4165827" y="763343"/>
            <a:ext cx="3681936" cy="333375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538207D-E8E6-4C93-981E-83781EB5E5A6}"/>
              </a:ext>
            </a:extLst>
          </p:cNvPr>
          <p:cNvSpPr txBox="1"/>
          <p:nvPr/>
        </p:nvSpPr>
        <p:spPr>
          <a:xfrm>
            <a:off x="5536172" y="1110404"/>
            <a:ext cx="9380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V504</a:t>
            </a:r>
          </a:p>
        </p:txBody>
      </p:sp>
      <p:pic>
        <p:nvPicPr>
          <p:cNvPr id="16" name="Picture 15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6DA80006-9D6F-43BF-8C46-401B23A625B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41"/>
          <a:stretch/>
        </p:blipFill>
        <p:spPr>
          <a:xfrm>
            <a:off x="7877906" y="763343"/>
            <a:ext cx="3681935" cy="333375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1B2D4BBA-981B-470F-981B-77AED5EA3F67}"/>
              </a:ext>
            </a:extLst>
          </p:cNvPr>
          <p:cNvSpPr txBox="1"/>
          <p:nvPr/>
        </p:nvSpPr>
        <p:spPr>
          <a:xfrm>
            <a:off x="4519091" y="2092297"/>
            <a:ext cx="11104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ntagonisti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53CC9B14-8E98-43B3-B364-1218F1FD71CE}"/>
              </a:ext>
            </a:extLst>
          </p:cNvPr>
          <p:cNvSpPr txBox="1"/>
          <p:nvPr/>
        </p:nvSpPr>
        <p:spPr>
          <a:xfrm>
            <a:off x="8419532" y="2093971"/>
            <a:ext cx="11104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ntagonisti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86A6EB93-6B66-4FB1-970E-833237B83860}"/>
              </a:ext>
            </a:extLst>
          </p:cNvPr>
          <p:cNvSpPr txBox="1"/>
          <p:nvPr/>
        </p:nvSpPr>
        <p:spPr>
          <a:xfrm>
            <a:off x="4448917" y="2940806"/>
            <a:ext cx="9827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ynergisti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51166D71-A5D3-470C-9C00-B299CA809AF7}"/>
              </a:ext>
            </a:extLst>
          </p:cNvPr>
          <p:cNvSpPr txBox="1"/>
          <p:nvPr/>
        </p:nvSpPr>
        <p:spPr>
          <a:xfrm>
            <a:off x="8358137" y="2963415"/>
            <a:ext cx="9827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ynergisti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BDB2D3BE-E30A-41C4-B06A-B100E6A5A991}"/>
              </a:ext>
            </a:extLst>
          </p:cNvPr>
          <p:cNvSpPr txBox="1"/>
          <p:nvPr/>
        </p:nvSpPr>
        <p:spPr>
          <a:xfrm>
            <a:off x="9891615" y="925738"/>
            <a:ext cx="1051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2780Ci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AA4D5E6B-AB8B-4B4B-918F-938E4051C627}"/>
              </a:ext>
            </a:extLst>
          </p:cNvPr>
          <p:cNvSpPr txBox="1"/>
          <p:nvPr/>
        </p:nvSpPr>
        <p:spPr>
          <a:xfrm>
            <a:off x="4325295" y="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DBF419F1-D825-41F6-9056-8F1704DECA52}"/>
              </a:ext>
            </a:extLst>
          </p:cNvPr>
          <p:cNvSpPr txBox="1"/>
          <p:nvPr/>
        </p:nvSpPr>
        <p:spPr>
          <a:xfrm>
            <a:off x="290391" y="57867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3613516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xmlns="" id="{863B50C4-75B6-469D-AB7C-F5F4F97B1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1F32F-4605-40C6-88EA-D0BD97672771}" type="slidenum">
              <a:rPr lang="en-US" smtClean="0"/>
              <a:t>12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645F0E2-1DCD-4374-BA1D-55FF1ECD763F}"/>
              </a:ext>
            </a:extLst>
          </p:cNvPr>
          <p:cNvSpPr txBox="1"/>
          <p:nvPr/>
        </p:nvSpPr>
        <p:spPr>
          <a:xfrm>
            <a:off x="4325295" y="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5991B5CB-C571-426F-9FAF-7172FA862292}"/>
              </a:ext>
            </a:extLst>
          </p:cNvPr>
          <p:cNvSpPr txBox="1"/>
          <p:nvPr/>
        </p:nvSpPr>
        <p:spPr>
          <a:xfrm>
            <a:off x="341644" y="83401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xmlns="" id="{8B1AA4A2-18F2-493F-8D7F-6EF78B198028}"/>
              </a:ext>
            </a:extLst>
          </p:cNvPr>
          <p:cNvGrpSpPr/>
          <p:nvPr/>
        </p:nvGrpSpPr>
        <p:grpSpPr>
          <a:xfrm>
            <a:off x="668978" y="977374"/>
            <a:ext cx="3712081" cy="3333750"/>
            <a:chOff x="1241756" y="948209"/>
            <a:chExt cx="3712081" cy="3333750"/>
          </a:xfrm>
        </p:grpSpPr>
        <p:pic>
          <p:nvPicPr>
            <p:cNvPr id="4" name="Picture 3" descr="A close up of a map&#10;&#10;Description automatically generated">
              <a:extLst>
                <a:ext uri="{FF2B5EF4-FFF2-40B4-BE49-F238E27FC236}">
                  <a16:creationId xmlns:a16="http://schemas.microsoft.com/office/drawing/2014/main" xmlns="" id="{19609754-3571-4E72-8DD6-7CDD774C43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326"/>
            <a:stretch/>
          </p:blipFill>
          <p:spPr>
            <a:xfrm>
              <a:off x="1241756" y="948209"/>
              <a:ext cx="3712081" cy="333375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70BB4D7B-5883-4D14-80E6-649213604AE9}"/>
                </a:ext>
              </a:extLst>
            </p:cNvPr>
            <p:cNvSpPr txBox="1"/>
            <p:nvPr/>
          </p:nvSpPr>
          <p:spPr>
            <a:xfrm>
              <a:off x="2757799" y="1374167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RK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12DB7DF4-AF88-41EC-AD58-955764C577B3}"/>
                </a:ext>
              </a:extLst>
            </p:cNvPr>
            <p:cNvSpPr txBox="1"/>
            <p:nvPr/>
          </p:nvSpPr>
          <p:spPr>
            <a:xfrm>
              <a:off x="3055798" y="2490361"/>
              <a:ext cx="982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ynergistic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1B985583-409E-4AC6-A7FF-0D17EEC713C7}"/>
                </a:ext>
              </a:extLst>
            </p:cNvPr>
            <p:cNvSpPr txBox="1"/>
            <p:nvPr/>
          </p:nvSpPr>
          <p:spPr>
            <a:xfrm>
              <a:off x="3045750" y="2297259"/>
              <a:ext cx="11104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ntagonistic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CEB526ED-F85A-4F11-80F5-A88C65AE84CC}"/>
              </a:ext>
            </a:extLst>
          </p:cNvPr>
          <p:cNvGrpSpPr/>
          <p:nvPr/>
        </p:nvGrpSpPr>
        <p:grpSpPr>
          <a:xfrm>
            <a:off x="4391107" y="987422"/>
            <a:ext cx="3651791" cy="3333750"/>
            <a:chOff x="931903" y="938161"/>
            <a:chExt cx="3651791" cy="3333750"/>
          </a:xfrm>
        </p:grpSpPr>
        <p:pic>
          <p:nvPicPr>
            <p:cNvPr id="11" name="Picture 10" descr="A close up of a map&#10;&#10;Description automatically generated">
              <a:extLst>
                <a:ext uri="{FF2B5EF4-FFF2-40B4-BE49-F238E27FC236}">
                  <a16:creationId xmlns:a16="http://schemas.microsoft.com/office/drawing/2014/main" xmlns="" id="{B92DDB2D-D432-4676-88C1-EFFE493EEE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555"/>
            <a:stretch/>
          </p:blipFill>
          <p:spPr>
            <a:xfrm>
              <a:off x="931903" y="938161"/>
              <a:ext cx="3651791" cy="333375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70C5135B-AABA-4D74-9419-8F8313E4C971}"/>
                </a:ext>
              </a:extLst>
            </p:cNvPr>
            <p:cNvSpPr txBox="1"/>
            <p:nvPr/>
          </p:nvSpPr>
          <p:spPr>
            <a:xfrm>
              <a:off x="3055798" y="1123381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RK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9A121D73-FF23-49E0-8C6B-7EDC6DACB9C3}"/>
                </a:ext>
              </a:extLst>
            </p:cNvPr>
            <p:cNvSpPr txBox="1"/>
            <p:nvPr/>
          </p:nvSpPr>
          <p:spPr>
            <a:xfrm>
              <a:off x="3055798" y="2490361"/>
              <a:ext cx="982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ynergistic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1FD1174C-9F5B-4742-BE20-962F92F9AB98}"/>
                </a:ext>
              </a:extLst>
            </p:cNvPr>
            <p:cNvSpPr txBox="1"/>
            <p:nvPr/>
          </p:nvSpPr>
          <p:spPr>
            <a:xfrm>
              <a:off x="3045750" y="2267115"/>
              <a:ext cx="11104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ntagonistic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05C4A71C-0CE4-457C-96CC-372467382B08}"/>
              </a:ext>
            </a:extLst>
          </p:cNvPr>
          <p:cNvGrpSpPr/>
          <p:nvPr/>
        </p:nvGrpSpPr>
        <p:grpSpPr>
          <a:xfrm>
            <a:off x="8052946" y="973227"/>
            <a:ext cx="3651791" cy="3333750"/>
            <a:chOff x="1070934" y="784272"/>
            <a:chExt cx="3651791" cy="3333750"/>
          </a:xfrm>
        </p:grpSpPr>
        <p:pic>
          <p:nvPicPr>
            <p:cNvPr id="17" name="Picture 16" descr="A close up of a map&#10;&#10;Description automatically generated">
              <a:extLst>
                <a:ext uri="{FF2B5EF4-FFF2-40B4-BE49-F238E27FC236}">
                  <a16:creationId xmlns:a16="http://schemas.microsoft.com/office/drawing/2014/main" xmlns="" id="{3FC75BFC-6DF3-40DB-A6E6-828DD774D9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555"/>
            <a:stretch/>
          </p:blipFill>
          <p:spPr>
            <a:xfrm>
              <a:off x="1070934" y="784272"/>
              <a:ext cx="3651791" cy="333375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B7E94080-3594-4568-8E60-12DAA5638A00}"/>
                </a:ext>
              </a:extLst>
            </p:cNvPr>
            <p:cNvSpPr txBox="1"/>
            <p:nvPr/>
          </p:nvSpPr>
          <p:spPr>
            <a:xfrm>
              <a:off x="2715801" y="1122957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RK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D0D277F0-90C7-45E6-9FCB-28BF04A90F19}"/>
                </a:ext>
              </a:extLst>
            </p:cNvPr>
            <p:cNvSpPr txBox="1"/>
            <p:nvPr/>
          </p:nvSpPr>
          <p:spPr>
            <a:xfrm>
              <a:off x="2573477" y="2345155"/>
              <a:ext cx="982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ynergistic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F572EB37-CBCD-451E-B434-38AB30FE112C}"/>
                </a:ext>
              </a:extLst>
            </p:cNvPr>
            <p:cNvSpPr txBox="1"/>
            <p:nvPr/>
          </p:nvSpPr>
          <p:spPr>
            <a:xfrm>
              <a:off x="2573477" y="2143370"/>
              <a:ext cx="11104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ntagonisti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9540681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8AEEAAD6-01D1-46A9-AC25-7B1EE4A0E935}"/>
              </a:ext>
            </a:extLst>
          </p:cNvPr>
          <p:cNvSpPr txBox="1"/>
          <p:nvPr/>
        </p:nvSpPr>
        <p:spPr>
          <a:xfrm>
            <a:off x="4830251" y="208289"/>
            <a:ext cx="16786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Supplementary Figure S6 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xmlns="" id="{CD088011-0FEC-47FF-84BC-F0DF6E1775F4}"/>
              </a:ext>
            </a:extLst>
          </p:cNvPr>
          <p:cNvGrpSpPr/>
          <p:nvPr/>
        </p:nvGrpSpPr>
        <p:grpSpPr>
          <a:xfrm>
            <a:off x="4206669" y="4860321"/>
            <a:ext cx="3971461" cy="246221"/>
            <a:chOff x="797687" y="3652191"/>
            <a:chExt cx="3971461" cy="246221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xmlns="" id="{88228B2B-1961-4709-BCCF-8988B6B12B3B}"/>
                </a:ext>
              </a:extLst>
            </p:cNvPr>
            <p:cNvSpPr/>
            <p:nvPr/>
          </p:nvSpPr>
          <p:spPr>
            <a:xfrm>
              <a:off x="797687" y="3724598"/>
              <a:ext cx="142194" cy="95520"/>
            </a:xfrm>
            <a:prstGeom prst="rect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b="1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xmlns="" id="{0B4D9783-4088-407F-A576-363D0A162162}"/>
                </a:ext>
              </a:extLst>
            </p:cNvPr>
            <p:cNvSpPr/>
            <p:nvPr/>
          </p:nvSpPr>
          <p:spPr>
            <a:xfrm>
              <a:off x="2059680" y="3724598"/>
              <a:ext cx="142194" cy="95520"/>
            </a:xfrm>
            <a:prstGeom prst="rect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b="1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xmlns="" id="{844B05A3-49B4-4F00-A061-CE4F5CC891E4}"/>
                </a:ext>
              </a:extLst>
            </p:cNvPr>
            <p:cNvSpPr/>
            <p:nvPr/>
          </p:nvSpPr>
          <p:spPr>
            <a:xfrm>
              <a:off x="3569665" y="3724598"/>
              <a:ext cx="142194" cy="9552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b="1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xmlns="" id="{23151D5D-135F-4403-A084-593F98DBBA24}"/>
                </a:ext>
              </a:extLst>
            </p:cNvPr>
            <p:cNvSpPr/>
            <p:nvPr/>
          </p:nvSpPr>
          <p:spPr>
            <a:xfrm>
              <a:off x="859103" y="3652191"/>
              <a:ext cx="391004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1000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Antagonism (CI&gt;1);          Additive effect (CI = 1);          Synergism (CI&lt;1)</a:t>
              </a:r>
              <a:r>
                <a:rPr lang="it-IT" sz="1000" b="1" dirty="0"/>
                <a:t> </a:t>
              </a:r>
              <a:endParaRPr lang="en-US" sz="1000" b="1" dirty="0"/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xmlns="" id="{2A3E85A4-6D28-41ED-9662-0F8DFF00D236}"/>
              </a:ext>
            </a:extLst>
          </p:cNvPr>
          <p:cNvGrpSpPr/>
          <p:nvPr/>
        </p:nvGrpSpPr>
        <p:grpSpPr>
          <a:xfrm>
            <a:off x="4065475" y="2089012"/>
            <a:ext cx="3381784" cy="1414559"/>
            <a:chOff x="3305652" y="1877999"/>
            <a:chExt cx="3381784" cy="1414559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xmlns="" id="{BE23E338-33E3-4DC5-A008-03DC3C2B4BA5}"/>
                </a:ext>
              </a:extLst>
            </p:cNvPr>
            <p:cNvSpPr txBox="1"/>
            <p:nvPr/>
          </p:nvSpPr>
          <p:spPr>
            <a:xfrm>
              <a:off x="3427360" y="1877999"/>
              <a:ext cx="31486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imultaneous treatment with VP and CP (Non-constant Ratio)</a:t>
              </a:r>
            </a:p>
          </p:txBody>
        </p: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xmlns="" id="{A64973AF-0A3D-48C9-A8C1-D36E5656AA82}"/>
                </a:ext>
              </a:extLst>
            </p:cNvPr>
            <p:cNvGrpSpPr/>
            <p:nvPr/>
          </p:nvGrpSpPr>
          <p:grpSpPr>
            <a:xfrm>
              <a:off x="3305652" y="1994296"/>
              <a:ext cx="3381784" cy="1298262"/>
              <a:chOff x="3305652" y="1994296"/>
              <a:chExt cx="3381784" cy="1298262"/>
            </a:xfrm>
          </p:grpSpPr>
          <p:graphicFrame>
            <p:nvGraphicFramePr>
              <p:cNvPr id="48" name="Object 47">
                <a:extLst>
                  <a:ext uri="{FF2B5EF4-FFF2-40B4-BE49-F238E27FC236}">
                    <a16:creationId xmlns:a16="http://schemas.microsoft.com/office/drawing/2014/main" xmlns="" id="{E598B87C-AB10-42B7-93BF-73DB5BDAD9C5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3487036" y="2195278"/>
              <a:ext cx="3200400" cy="109728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4" name="Worksheet" r:id="rId3" imgW="4276657" imgH="1809660" progId="Excel.Sheet.12">
                      <p:embed/>
                    </p:oleObj>
                  </mc:Choice>
                  <mc:Fallback>
                    <p:oleObj name="Worksheet" r:id="rId3" imgW="4276657" imgH="1809660" progId="Excel.Sheet.12">
                      <p:embed/>
                      <p:pic>
                        <p:nvPicPr>
                          <p:cNvPr id="48" name="Object 47">
                            <a:extLst>
                              <a:ext uri="{FF2B5EF4-FFF2-40B4-BE49-F238E27FC236}">
                                <a16:creationId xmlns:a16="http://schemas.microsoft.com/office/drawing/2014/main" xmlns="" id="{E598B87C-AB10-42B7-93BF-73DB5BDAD9C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3487036" y="2195278"/>
                            <a:ext cx="3200400" cy="109728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xmlns="" id="{905BD414-E9DA-494A-86A4-369A15285A61}"/>
                  </a:ext>
                </a:extLst>
              </p:cNvPr>
              <p:cNvGrpSpPr/>
              <p:nvPr/>
            </p:nvGrpSpPr>
            <p:grpSpPr>
              <a:xfrm>
                <a:off x="3502365" y="1994296"/>
                <a:ext cx="3175957" cy="230832"/>
                <a:chOff x="3541037" y="613597"/>
                <a:chExt cx="3175957" cy="230832"/>
              </a:xfrm>
            </p:grpSpPr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xmlns="" id="{6660B48A-DDC8-4D8D-9ADA-E97B7C396679}"/>
                    </a:ext>
                  </a:extLst>
                </p:cNvPr>
                <p:cNvSpPr txBox="1"/>
                <p:nvPr/>
              </p:nvSpPr>
              <p:spPr>
                <a:xfrm>
                  <a:off x="4840475" y="613597"/>
                  <a:ext cx="57740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VP (µM)</a:t>
                  </a:r>
                </a:p>
              </p:txBody>
            </p: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xmlns="" id="{B27D9114-662F-4E5F-91FB-81AC7F7E4B5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3541037" y="748273"/>
                  <a:ext cx="1365353" cy="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>
                  <a:extLst>
                    <a:ext uri="{FF2B5EF4-FFF2-40B4-BE49-F238E27FC236}">
                      <a16:creationId xmlns:a16="http://schemas.microsoft.com/office/drawing/2014/main" xmlns="" id="{01CB30CB-5EEE-4B83-8738-9410EBCA82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5351641" y="743721"/>
                  <a:ext cx="1365353" cy="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xmlns="" id="{D85DDCEA-D51A-4AB9-A909-63B5736182F8}"/>
                  </a:ext>
                </a:extLst>
              </p:cNvPr>
              <p:cNvGrpSpPr/>
              <p:nvPr/>
            </p:nvGrpSpPr>
            <p:grpSpPr>
              <a:xfrm>
                <a:off x="3305652" y="2204112"/>
                <a:ext cx="230832" cy="1065605"/>
                <a:chOff x="3305652" y="2176816"/>
                <a:chExt cx="230832" cy="1065605"/>
              </a:xfrm>
            </p:grpSpPr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xmlns="" id="{C8D6F62F-BAD0-4230-AB53-B86F595040F2}"/>
                    </a:ext>
                  </a:extLst>
                </p:cNvPr>
                <p:cNvSpPr txBox="1"/>
                <p:nvPr/>
              </p:nvSpPr>
              <p:spPr>
                <a:xfrm rot="16200000">
                  <a:off x="3136374" y="2614357"/>
                  <a:ext cx="569387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CP (µM)</a:t>
                  </a:r>
                </a:p>
              </p:txBody>
            </p:sp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xmlns="" id="{7D41EC19-C193-4F97-8166-126401F33F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34716" y="2939403"/>
                  <a:ext cx="0" cy="30301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xmlns="" id="{F0162C1B-3E8B-4DB7-8774-5C5248534FF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30164" y="2176816"/>
                  <a:ext cx="0" cy="32643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9EF0F3E4-57BB-4C0F-B086-A3C8928B8B1C}"/>
              </a:ext>
            </a:extLst>
          </p:cNvPr>
          <p:cNvSpPr txBox="1"/>
          <p:nvPr/>
        </p:nvSpPr>
        <p:spPr>
          <a:xfrm>
            <a:off x="3885961" y="72662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FFFB22C0-0FBE-46DF-87C5-B4251D882853}"/>
              </a:ext>
            </a:extLst>
          </p:cNvPr>
          <p:cNvSpPr txBox="1"/>
          <p:nvPr/>
        </p:nvSpPr>
        <p:spPr>
          <a:xfrm>
            <a:off x="3885961" y="2288455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7F598F3E-A574-4807-8FAB-EFF7D2A78AC1}"/>
              </a:ext>
            </a:extLst>
          </p:cNvPr>
          <p:cNvSpPr txBox="1"/>
          <p:nvPr/>
        </p:nvSpPr>
        <p:spPr>
          <a:xfrm>
            <a:off x="3885961" y="374508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8712CDF0-D77D-45E0-A69D-4035DC211DE0}"/>
              </a:ext>
            </a:extLst>
          </p:cNvPr>
          <p:cNvGrpSpPr/>
          <p:nvPr/>
        </p:nvGrpSpPr>
        <p:grpSpPr>
          <a:xfrm>
            <a:off x="4065475" y="627593"/>
            <a:ext cx="3353886" cy="1390582"/>
            <a:chOff x="11927" y="1283465"/>
            <a:chExt cx="3353886" cy="1390582"/>
          </a:xfrm>
        </p:grpSpPr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xmlns="" id="{BC541AD3-E915-4F07-AACA-7E9ADC90EF77}"/>
                </a:ext>
              </a:extLst>
            </p:cNvPr>
            <p:cNvGrpSpPr/>
            <p:nvPr/>
          </p:nvGrpSpPr>
          <p:grpSpPr>
            <a:xfrm>
              <a:off x="11927" y="1283465"/>
              <a:ext cx="3352197" cy="1389009"/>
              <a:chOff x="3364797" y="490349"/>
              <a:chExt cx="3352197" cy="1389009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xmlns="" id="{01763039-4F15-49E5-AA3F-673B62375BD8}"/>
                  </a:ext>
                </a:extLst>
              </p:cNvPr>
              <p:cNvSpPr txBox="1"/>
              <p:nvPr/>
            </p:nvSpPr>
            <p:spPr>
              <a:xfrm>
                <a:off x="3395251" y="490349"/>
                <a:ext cx="33217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Simultaneous treatment with VP and CDDP (Non-constant Ratio)</a:t>
                </a:r>
              </a:p>
            </p:txBody>
          </p:sp>
          <p:grpSp>
            <p:nvGrpSpPr>
              <p:cNvPr id="75" name="Group 74">
                <a:extLst>
                  <a:ext uri="{FF2B5EF4-FFF2-40B4-BE49-F238E27FC236}">
                    <a16:creationId xmlns:a16="http://schemas.microsoft.com/office/drawing/2014/main" xmlns="" id="{5395048A-73CF-4398-BAA3-49D23A98B311}"/>
                  </a:ext>
                </a:extLst>
              </p:cNvPr>
              <p:cNvGrpSpPr/>
              <p:nvPr/>
            </p:nvGrpSpPr>
            <p:grpSpPr>
              <a:xfrm>
                <a:off x="3364797" y="613597"/>
                <a:ext cx="3352197" cy="1265761"/>
                <a:chOff x="3364797" y="613597"/>
                <a:chExt cx="3352197" cy="1265761"/>
              </a:xfrm>
            </p:grpSpPr>
            <p:grpSp>
              <p:nvGrpSpPr>
                <p:cNvPr id="50" name="Group 49">
                  <a:extLst>
                    <a:ext uri="{FF2B5EF4-FFF2-40B4-BE49-F238E27FC236}">
                      <a16:creationId xmlns:a16="http://schemas.microsoft.com/office/drawing/2014/main" xmlns="" id="{4F96B2B3-1A2E-461F-BCF0-AB47B3FC54A1}"/>
                    </a:ext>
                  </a:extLst>
                </p:cNvPr>
                <p:cNvGrpSpPr/>
                <p:nvPr/>
              </p:nvGrpSpPr>
              <p:grpSpPr>
                <a:xfrm>
                  <a:off x="3541037" y="613597"/>
                  <a:ext cx="3175957" cy="230832"/>
                  <a:chOff x="3541037" y="613597"/>
                  <a:chExt cx="3175957" cy="230832"/>
                </a:xfrm>
              </p:grpSpPr>
              <p:sp>
                <p:nvSpPr>
                  <p:cNvPr id="6" name="TextBox 5">
                    <a:extLst>
                      <a:ext uri="{FF2B5EF4-FFF2-40B4-BE49-F238E27FC236}">
                        <a16:creationId xmlns:a16="http://schemas.microsoft.com/office/drawing/2014/main" xmlns="" id="{1392AE82-E5F9-4855-A887-BC53D3F99E96}"/>
                      </a:ext>
                    </a:extLst>
                  </p:cNvPr>
                  <p:cNvSpPr txBox="1"/>
                  <p:nvPr/>
                </p:nvSpPr>
                <p:spPr>
                  <a:xfrm>
                    <a:off x="4840475" y="613597"/>
                    <a:ext cx="577402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VP (µM)</a:t>
                    </a:r>
                  </a:p>
                </p:txBody>
              </p:sp>
              <p:cxnSp>
                <p:nvCxnSpPr>
                  <p:cNvPr id="34" name="Straight Connector 33">
                    <a:extLst>
                      <a:ext uri="{FF2B5EF4-FFF2-40B4-BE49-F238E27FC236}">
                        <a16:creationId xmlns:a16="http://schemas.microsoft.com/office/drawing/2014/main" xmlns="" id="{88E6550E-6C8E-4932-AA99-669B160BC8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3541037" y="748273"/>
                    <a:ext cx="1365353" cy="1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Straight Connector 38">
                    <a:extLst>
                      <a:ext uri="{FF2B5EF4-FFF2-40B4-BE49-F238E27FC236}">
                        <a16:creationId xmlns:a16="http://schemas.microsoft.com/office/drawing/2014/main" xmlns="" id="{F9627C82-6881-4DE4-A5B5-32C561B62F3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5351641" y="743721"/>
                    <a:ext cx="1365353" cy="1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1" name="Group 50">
                  <a:extLst>
                    <a:ext uri="{FF2B5EF4-FFF2-40B4-BE49-F238E27FC236}">
                      <a16:creationId xmlns:a16="http://schemas.microsoft.com/office/drawing/2014/main" xmlns="" id="{69503C93-EBCB-4AAF-B1AF-024AC7DDD2C9}"/>
                    </a:ext>
                  </a:extLst>
                </p:cNvPr>
                <p:cNvGrpSpPr/>
                <p:nvPr/>
              </p:nvGrpSpPr>
              <p:grpSpPr>
                <a:xfrm>
                  <a:off x="3364797" y="779181"/>
                  <a:ext cx="230832" cy="1100177"/>
                  <a:chOff x="3364797" y="779181"/>
                  <a:chExt cx="230832" cy="1100177"/>
                </a:xfrm>
              </p:grpSpPr>
              <p:sp>
                <p:nvSpPr>
                  <p:cNvPr id="7" name="TextBox 6">
                    <a:extLst>
                      <a:ext uri="{FF2B5EF4-FFF2-40B4-BE49-F238E27FC236}">
                        <a16:creationId xmlns:a16="http://schemas.microsoft.com/office/drawing/2014/main" xmlns="" id="{CCD32550-EBE1-4FFA-8435-97D30B46834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123384" y="1233660"/>
                    <a:ext cx="713657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CDDP (µM)</a:t>
                    </a:r>
                  </a:p>
                </p:txBody>
              </p:sp>
              <p:cxnSp>
                <p:nvCxnSpPr>
                  <p:cNvPr id="40" name="Straight Connector 39">
                    <a:extLst>
                      <a:ext uri="{FF2B5EF4-FFF2-40B4-BE49-F238E27FC236}">
                        <a16:creationId xmlns:a16="http://schemas.microsoft.com/office/drawing/2014/main" xmlns="" id="{D2E8D35F-CB68-4EDE-B751-4187F38BF38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484206" y="1622578"/>
                    <a:ext cx="2830" cy="25678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43">
                    <a:extLst>
                      <a:ext uri="{FF2B5EF4-FFF2-40B4-BE49-F238E27FC236}">
                        <a16:creationId xmlns:a16="http://schemas.microsoft.com/office/drawing/2014/main" xmlns="" id="{0CF643E4-B918-4108-A6FB-2BD77CE24D1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489308" y="779181"/>
                    <a:ext cx="0" cy="290407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aphicFrame>
          <p:nvGraphicFramePr>
            <p:cNvPr id="81" name="Object 80">
              <a:extLst>
                <a:ext uri="{FF2B5EF4-FFF2-40B4-BE49-F238E27FC236}">
                  <a16:creationId xmlns:a16="http://schemas.microsoft.com/office/drawing/2014/main" xmlns="" id="{529EAA9B-2CAD-4AC3-9E4E-FDF3D2CEACA1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165413" y="1576767"/>
            <a:ext cx="3200400" cy="10972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5" name="Worksheet" r:id="rId5" imgW="4352857" imgH="1809660" progId="Excel.Sheet.12">
                    <p:embed/>
                  </p:oleObj>
                </mc:Choice>
                <mc:Fallback>
                  <p:oleObj name="Worksheet" r:id="rId5" imgW="4352857" imgH="1809660" progId="Excel.Sheet.12">
                    <p:embed/>
                    <p:pic>
                      <p:nvPicPr>
                        <p:cNvPr id="81" name="Object 80">
                          <a:extLst>
                            <a:ext uri="{FF2B5EF4-FFF2-40B4-BE49-F238E27FC236}">
                              <a16:creationId xmlns:a16="http://schemas.microsoft.com/office/drawing/2014/main" xmlns="" id="{529EAA9B-2CAD-4AC3-9E4E-FDF3D2CEACA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65413" y="1576767"/>
                          <a:ext cx="3200400" cy="109728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C65A68B0-3D0E-48E3-A53E-B72C8B1C49E4}"/>
              </a:ext>
            </a:extLst>
          </p:cNvPr>
          <p:cNvGrpSpPr/>
          <p:nvPr/>
        </p:nvGrpSpPr>
        <p:grpSpPr>
          <a:xfrm>
            <a:off x="4065475" y="3538220"/>
            <a:ext cx="3398814" cy="1361453"/>
            <a:chOff x="3370004" y="1299385"/>
            <a:chExt cx="3398814" cy="1361453"/>
          </a:xfrm>
        </p:grpSpPr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4A2FAB45-79AD-44BE-82C1-F296FE23CD56}"/>
                </a:ext>
              </a:extLst>
            </p:cNvPr>
            <p:cNvSpPr txBox="1"/>
            <p:nvPr/>
          </p:nvSpPr>
          <p:spPr>
            <a:xfrm>
              <a:off x="3511195" y="1299385"/>
              <a:ext cx="3257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Simultaneous treatment with VP and Taxol (Non-constant Ratio)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E9B0C50D-EFB3-452C-ABF9-C232FC39BDD7}"/>
                </a:ext>
              </a:extLst>
            </p:cNvPr>
            <p:cNvGrpSpPr/>
            <p:nvPr/>
          </p:nvGrpSpPr>
          <p:grpSpPr>
            <a:xfrm>
              <a:off x="3370004" y="1395338"/>
              <a:ext cx="3381049" cy="1239914"/>
              <a:chOff x="3370004" y="1395338"/>
              <a:chExt cx="3381049" cy="1239914"/>
            </a:xfrm>
          </p:grpSpPr>
          <p:grpSp>
            <p:nvGrpSpPr>
              <p:cNvPr id="86" name="Group 85">
                <a:extLst>
                  <a:ext uri="{FF2B5EF4-FFF2-40B4-BE49-F238E27FC236}">
                    <a16:creationId xmlns:a16="http://schemas.microsoft.com/office/drawing/2014/main" xmlns="" id="{3F665B92-8A57-4BA4-9D55-021D36C36377}"/>
                  </a:ext>
                </a:extLst>
              </p:cNvPr>
              <p:cNvGrpSpPr/>
              <p:nvPr/>
            </p:nvGrpSpPr>
            <p:grpSpPr>
              <a:xfrm>
                <a:off x="3575096" y="1395338"/>
                <a:ext cx="3175957" cy="230832"/>
                <a:chOff x="3575096" y="1381690"/>
                <a:chExt cx="3175957" cy="230832"/>
              </a:xfrm>
            </p:grpSpPr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xmlns="" id="{4810BC76-EC5F-4D66-B7E5-46F9079D8443}"/>
                    </a:ext>
                  </a:extLst>
                </p:cNvPr>
                <p:cNvSpPr txBox="1"/>
                <p:nvPr/>
              </p:nvSpPr>
              <p:spPr>
                <a:xfrm>
                  <a:off x="4874534" y="1381690"/>
                  <a:ext cx="57740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VP (µM)</a:t>
                  </a:r>
                </a:p>
              </p:txBody>
            </p:sp>
            <p:cxnSp>
              <p:nvCxnSpPr>
                <p:cNvPr id="84" name="Straight Connector 83">
                  <a:extLst>
                    <a:ext uri="{FF2B5EF4-FFF2-40B4-BE49-F238E27FC236}">
                      <a16:creationId xmlns:a16="http://schemas.microsoft.com/office/drawing/2014/main" xmlns="" id="{4DA9B902-E002-40B5-9C4D-E1DA605B01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3575096" y="1516366"/>
                  <a:ext cx="1365353" cy="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>
                  <a:extLst>
                    <a:ext uri="{FF2B5EF4-FFF2-40B4-BE49-F238E27FC236}">
                      <a16:creationId xmlns:a16="http://schemas.microsoft.com/office/drawing/2014/main" xmlns="" id="{B6B7AAF9-A6E8-466C-90B7-AA797F5FF2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5385700" y="1511814"/>
                  <a:ext cx="1365353" cy="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2" name="Group 91">
                <a:extLst>
                  <a:ext uri="{FF2B5EF4-FFF2-40B4-BE49-F238E27FC236}">
                    <a16:creationId xmlns:a16="http://schemas.microsoft.com/office/drawing/2014/main" xmlns="" id="{E7339FD7-9D05-4B83-AE84-E3A027E775CD}"/>
                  </a:ext>
                </a:extLst>
              </p:cNvPr>
              <p:cNvGrpSpPr/>
              <p:nvPr/>
            </p:nvGrpSpPr>
            <p:grpSpPr>
              <a:xfrm>
                <a:off x="3370004" y="1569647"/>
                <a:ext cx="230832" cy="1065605"/>
                <a:chOff x="3888599" y="3002326"/>
                <a:chExt cx="230832" cy="1065605"/>
              </a:xfrm>
            </p:grpSpPr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xmlns="" id="{C9AA5FCA-42E7-49D6-AA77-7C2A78C6ED22}"/>
                    </a:ext>
                  </a:extLst>
                </p:cNvPr>
                <p:cNvSpPr txBox="1"/>
                <p:nvPr/>
              </p:nvSpPr>
              <p:spPr>
                <a:xfrm rot="16200000">
                  <a:off x="3650392" y="3439867"/>
                  <a:ext cx="70724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Taxol (µM)</a:t>
                  </a:r>
                </a:p>
              </p:txBody>
            </p:sp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xmlns="" id="{948CDAED-F334-4C0A-9232-1CEA1AB1C13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17662" y="3798991"/>
                  <a:ext cx="0" cy="2689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Straight Connector 88">
                  <a:extLst>
                    <a:ext uri="{FF2B5EF4-FFF2-40B4-BE49-F238E27FC236}">
                      <a16:creationId xmlns:a16="http://schemas.microsoft.com/office/drawing/2014/main" xmlns="" id="{2E994027-88CB-47D7-8075-E9541FFF6C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13110" y="3002326"/>
                  <a:ext cx="0" cy="32643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xmlns="" id="{0D09104B-639D-4893-9A16-269EA335EE10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3531678" y="1563558"/>
            <a:ext cx="3200400" cy="10972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6" name="Worksheet" r:id="rId7" imgW="4276657" imgH="1409610" progId="Excel.Sheet.12">
                    <p:embed/>
                  </p:oleObj>
                </mc:Choice>
                <mc:Fallback>
                  <p:oleObj name="Worksheet" r:id="rId7" imgW="4276657" imgH="1409610" progId="Excel.Sheet.12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xmlns="" id="{0D09104B-639D-4893-9A16-269EA335EE1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531678" y="1563558"/>
                          <a:ext cx="3200400" cy="109728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68706124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xmlns="" id="{BB09879E-1134-4974-A356-978597B2329B}"/>
              </a:ext>
            </a:extLst>
          </p:cNvPr>
          <p:cNvGrpSpPr/>
          <p:nvPr/>
        </p:nvGrpSpPr>
        <p:grpSpPr>
          <a:xfrm>
            <a:off x="398928" y="755802"/>
            <a:ext cx="7262322" cy="3061080"/>
            <a:chOff x="398928" y="755802"/>
            <a:chExt cx="7262322" cy="3061080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xmlns="" id="{511B1CD6-AB03-44BA-B3AB-34244AC4B47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4797" y="991820"/>
              <a:ext cx="1371600" cy="1430806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DB78EDC2-16D3-469C-9F67-34ED735DD9E2}"/>
                </a:ext>
              </a:extLst>
            </p:cNvPr>
            <p:cNvSpPr txBox="1"/>
            <p:nvPr/>
          </p:nvSpPr>
          <p:spPr>
            <a:xfrm>
              <a:off x="944337" y="755802"/>
              <a:ext cx="8150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Control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xmlns="" id="{40FB762B-DB62-4B5D-9C40-78F36D580549}"/>
                </a:ext>
              </a:extLst>
            </p:cNvPr>
            <p:cNvSpPr txBox="1"/>
            <p:nvPr/>
          </p:nvSpPr>
          <p:spPr>
            <a:xfrm>
              <a:off x="2474420" y="755802"/>
              <a:ext cx="41549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VP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4701ED47-8E1B-4000-B1B9-8617AE7249E5}"/>
                </a:ext>
              </a:extLst>
            </p:cNvPr>
            <p:cNvSpPr txBox="1"/>
            <p:nvPr/>
          </p:nvSpPr>
          <p:spPr>
            <a:xfrm>
              <a:off x="3810460" y="755802"/>
              <a:ext cx="6623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CDDP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13579AE0-B9E7-4512-A6D1-A72FC7D40584}"/>
                </a:ext>
              </a:extLst>
            </p:cNvPr>
            <p:cNvSpPr txBox="1"/>
            <p:nvPr/>
          </p:nvSpPr>
          <p:spPr>
            <a:xfrm>
              <a:off x="5296976" y="755802"/>
              <a:ext cx="4026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CP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FFA69619-6288-487A-B17F-278469C5E922}"/>
                </a:ext>
              </a:extLst>
            </p:cNvPr>
            <p:cNvSpPr txBox="1"/>
            <p:nvPr/>
          </p:nvSpPr>
          <p:spPr>
            <a:xfrm>
              <a:off x="6614899" y="755802"/>
              <a:ext cx="6194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Taxol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1AB07F2E-F851-4875-B8D8-9C723381CA0E}"/>
                </a:ext>
              </a:extLst>
            </p:cNvPr>
            <p:cNvSpPr txBox="1"/>
            <p:nvPr/>
          </p:nvSpPr>
          <p:spPr>
            <a:xfrm rot="16200000">
              <a:off x="241931" y="1562582"/>
              <a:ext cx="7064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OV90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xmlns="" id="{F0E896A2-74E4-46DD-AC4D-00D37D6AE8B7}"/>
                </a:ext>
              </a:extLst>
            </p:cNvPr>
            <p:cNvSpPr/>
            <p:nvPr/>
          </p:nvSpPr>
          <p:spPr>
            <a:xfrm rot="16200000">
              <a:off x="52839" y="2958693"/>
              <a:ext cx="106150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A2780Cis</a:t>
              </a:r>
              <a:endParaRPr lang="en-US" dirty="0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xmlns="" id="{57BB505B-4951-46AB-BA50-EABB7D4E6F6E}"/>
                </a:ext>
              </a:extLst>
            </p:cNvPr>
            <p:cNvCxnSpPr>
              <a:cxnSpLocks/>
            </p:cNvCxnSpPr>
            <p:nvPr/>
          </p:nvCxnSpPr>
          <p:spPr>
            <a:xfrm>
              <a:off x="690743" y="2280213"/>
              <a:ext cx="439838" cy="0"/>
            </a:xfrm>
            <a:prstGeom prst="line">
              <a:avLst/>
            </a:prstGeom>
            <a:ln w="571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98CD7820-5A5C-4D9E-B2D1-D07CF37B10B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4797" y="2445282"/>
              <a:ext cx="1367624" cy="13716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64BD1A22-6859-4A1A-BCF7-D0EFDE584DF0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62343" y="2445282"/>
              <a:ext cx="1371600" cy="137160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xmlns="" id="{EC7C83B2-C11D-44AF-AAD5-E0B028065F46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76562" y="2445282"/>
              <a:ext cx="1371600" cy="137160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xmlns="" id="{9B517D15-8F9A-4F02-8CA0-49E9F5E5D678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79206" y="2445282"/>
              <a:ext cx="1371600" cy="1371600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xmlns="" id="{9B055DF3-F0F0-4FED-9F12-3DB5E8AF3A60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289650" y="2445282"/>
              <a:ext cx="1371600" cy="1371600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xmlns="" id="{5D1B80D5-93BC-4A3E-AE5B-660165B1B5D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062343" y="1005907"/>
              <a:ext cx="1371600" cy="1416719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xmlns="" id="{B7F82C45-71A1-4C01-A106-2290825F5D67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76562" y="1005907"/>
              <a:ext cx="1371600" cy="1416719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xmlns="" id="{133FA26E-D2D8-4886-8DE0-A1011D9EF8E5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879206" y="1005908"/>
              <a:ext cx="1371600" cy="1416718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xmlns="" id="{011C1B36-30B5-4B35-AB50-C1D2A1EE50C1}"/>
                </a:ext>
              </a:extLst>
            </p:cNvPr>
            <p:cNvPicPr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289650" y="1016903"/>
              <a:ext cx="1371600" cy="1405723"/>
            </a:xfrm>
            <a:prstGeom prst="rect">
              <a:avLst/>
            </a:prstGeom>
          </p:spPr>
        </p:pic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4C268ED-F61A-429C-95AE-1A8C22838787}"/>
              </a:ext>
            </a:extLst>
          </p:cNvPr>
          <p:cNvSpPr txBox="1"/>
          <p:nvPr/>
        </p:nvSpPr>
        <p:spPr>
          <a:xfrm>
            <a:off x="4556583" y="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7</a:t>
            </a:r>
          </a:p>
        </p:txBody>
      </p:sp>
    </p:spTree>
    <p:extLst>
      <p:ext uri="{BB962C8B-B14F-4D97-AF65-F5344CB8AC3E}">
        <p14:creationId xmlns:p14="http://schemas.microsoft.com/office/powerpoint/2010/main" val="2690261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12579ABB-4313-4078-8D18-02A1F959743F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0516" y="425585"/>
            <a:ext cx="3840480" cy="32004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1E6E87E3-B1E8-41C0-B84C-E9500F1589CD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60516" y="3295457"/>
            <a:ext cx="3840480" cy="32004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149E6C5D-3B10-4CC7-8E2B-298ECEDA9E63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177772" y="3295457"/>
            <a:ext cx="3840480" cy="3200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C1701C6F-ECE2-445B-B86C-1D16FE762AFD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177772" y="425585"/>
            <a:ext cx="3840480" cy="3200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16B43397-5D95-4511-BF67-CCE21FE438F1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8091004" y="425585"/>
            <a:ext cx="3840480" cy="3200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877A75D8-E8BB-4248-9110-91C844021191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8091004" y="3295457"/>
            <a:ext cx="3840480" cy="3200400"/>
          </a:xfrm>
          <a:prstGeom prst="rect">
            <a:avLst/>
          </a:prstGeom>
        </p:spPr>
      </p:pic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xmlns="" id="{89835EF8-AB92-4A3F-868A-860B5CF35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2</a:t>
            </a:fld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0786C506-67F5-4BCC-8808-23694EF566BD}"/>
              </a:ext>
            </a:extLst>
          </p:cNvPr>
          <p:cNvSpPr txBox="1"/>
          <p:nvPr/>
        </p:nvSpPr>
        <p:spPr>
          <a:xfrm>
            <a:off x="5032898" y="30718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S1</a:t>
            </a:r>
          </a:p>
        </p:txBody>
      </p:sp>
    </p:spTree>
    <p:extLst>
      <p:ext uri="{BB962C8B-B14F-4D97-AF65-F5344CB8AC3E}">
        <p14:creationId xmlns:p14="http://schemas.microsoft.com/office/powerpoint/2010/main" val="39464624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81DEBE15-D697-4AD8-9BE7-A170BCB87FFB}"/>
              </a:ext>
            </a:extLst>
          </p:cNvPr>
          <p:cNvSpPr txBox="1"/>
          <p:nvPr/>
        </p:nvSpPr>
        <p:spPr>
          <a:xfrm>
            <a:off x="4825297" y="-25252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S2</a:t>
            </a:r>
          </a:p>
        </p:txBody>
      </p:sp>
      <p:grpSp>
        <p:nvGrpSpPr>
          <p:cNvPr id="74" name="Group 73">
            <a:extLst>
              <a:ext uri="{FF2B5EF4-FFF2-40B4-BE49-F238E27FC236}">
                <a16:creationId xmlns:a16="http://schemas.microsoft.com/office/drawing/2014/main" xmlns="" id="{F9E1C1C5-A3F3-46D9-95E5-D8BC6CD7C305}"/>
              </a:ext>
            </a:extLst>
          </p:cNvPr>
          <p:cNvGrpSpPr/>
          <p:nvPr/>
        </p:nvGrpSpPr>
        <p:grpSpPr>
          <a:xfrm>
            <a:off x="615622" y="314915"/>
            <a:ext cx="3200400" cy="3200400"/>
            <a:chOff x="548984" y="3149758"/>
            <a:chExt cx="2743200" cy="2743200"/>
          </a:xfrm>
        </p:grpSpPr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xmlns="" id="{FBBDDC56-FC8A-4086-B35F-1F2054A0E1BC}"/>
                </a:ext>
              </a:extLst>
            </p:cNvPr>
            <p:cNvGrpSpPr/>
            <p:nvPr/>
          </p:nvGrpSpPr>
          <p:grpSpPr>
            <a:xfrm>
              <a:off x="548984" y="3149758"/>
              <a:ext cx="2743200" cy="2743200"/>
              <a:chOff x="4353199" y="251460"/>
              <a:chExt cx="2743200" cy="2743200"/>
            </a:xfrm>
          </p:grpSpPr>
          <p:pic>
            <p:nvPicPr>
              <p:cNvPr id="77" name="Picture 76" descr="A close up of a map&#10;&#10;Description generated with very high confidence">
                <a:extLst>
                  <a:ext uri="{FF2B5EF4-FFF2-40B4-BE49-F238E27FC236}">
                    <a16:creationId xmlns:a16="http://schemas.microsoft.com/office/drawing/2014/main" xmlns="" id="{841F0B0F-0297-443B-89AC-3518F859C1BB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6916"/>
              <a:stretch/>
            </p:blipFill>
            <p:spPr>
              <a:xfrm>
                <a:off x="4353199" y="251460"/>
                <a:ext cx="2743200" cy="2743200"/>
              </a:xfrm>
              <a:prstGeom prst="rect">
                <a:avLst/>
              </a:prstGeom>
            </p:spPr>
          </p:pic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xmlns="" id="{5ABAF1CD-FAB4-480A-AB70-65203369B504}"/>
                  </a:ext>
                </a:extLst>
              </p:cNvPr>
              <p:cNvSpPr txBox="1"/>
              <p:nvPr/>
            </p:nvSpPr>
            <p:spPr>
              <a:xfrm>
                <a:off x="5402541" y="2014062"/>
                <a:ext cx="1070623" cy="2638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C</a:t>
                </a:r>
                <a:r>
                  <a:rPr lang="en-US" sz="14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96.208</a:t>
                </a:r>
              </a:p>
            </p:txBody>
          </p:sp>
        </p:grp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xmlns="" id="{77276DA2-9E6A-42EC-B6D6-F9B6AFA0380F}"/>
                </a:ext>
              </a:extLst>
            </p:cNvPr>
            <p:cNvSpPr txBox="1"/>
            <p:nvPr/>
          </p:nvSpPr>
          <p:spPr>
            <a:xfrm>
              <a:off x="1835970" y="3618559"/>
              <a:ext cx="593625" cy="2638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V-90</a:t>
              </a:r>
            </a:p>
          </p:txBody>
        </p: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xmlns="" id="{81C971F4-CB6C-485A-8A21-BCDF431D0C49}"/>
              </a:ext>
            </a:extLst>
          </p:cNvPr>
          <p:cNvGrpSpPr/>
          <p:nvPr/>
        </p:nvGrpSpPr>
        <p:grpSpPr>
          <a:xfrm>
            <a:off x="615622" y="3515315"/>
            <a:ext cx="3200400" cy="3200400"/>
            <a:chOff x="4126846" y="323315"/>
            <a:chExt cx="3200400" cy="3200400"/>
          </a:xfrm>
        </p:grpSpPr>
        <p:pic>
          <p:nvPicPr>
            <p:cNvPr id="80" name="Picture 79" descr="A close up of a map&#10;&#10;Description generated with very high confidence">
              <a:extLst>
                <a:ext uri="{FF2B5EF4-FFF2-40B4-BE49-F238E27FC236}">
                  <a16:creationId xmlns:a16="http://schemas.microsoft.com/office/drawing/2014/main" xmlns="" id="{B64118C3-C36A-44E4-9C42-1007C6D4A89D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294"/>
            <a:stretch/>
          </p:blipFill>
          <p:spPr>
            <a:xfrm>
              <a:off x="4126846" y="323315"/>
              <a:ext cx="3200400" cy="3200400"/>
            </a:xfrm>
            <a:prstGeom prst="rect">
              <a:avLst/>
            </a:prstGeom>
          </p:spPr>
        </p:pic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B140FBC3-263D-42CE-9C2C-0004C4D3DA9C}"/>
                </a:ext>
              </a:extLst>
            </p:cNvPr>
            <p:cNvSpPr txBox="1"/>
            <p:nvPr/>
          </p:nvSpPr>
          <p:spPr>
            <a:xfrm>
              <a:off x="5479429" y="652299"/>
              <a:ext cx="6925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V-90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28C2A028-7929-4000-8F07-B2C1B86260A2}"/>
                </a:ext>
              </a:extLst>
            </p:cNvPr>
            <p:cNvSpPr txBox="1"/>
            <p:nvPr/>
          </p:nvSpPr>
          <p:spPr>
            <a:xfrm>
              <a:off x="5040254" y="2303120"/>
              <a:ext cx="13484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= 2.16766</a:t>
              </a:r>
            </a:p>
          </p:txBody>
        </p:sp>
      </p:grpSp>
      <p:pic>
        <p:nvPicPr>
          <p:cNvPr id="83" name="Picture 82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AC3798F3-18AD-4384-8AC1-15726A364C5F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612"/>
          <a:stretch/>
        </p:blipFill>
        <p:spPr>
          <a:xfrm>
            <a:off x="4009074" y="314915"/>
            <a:ext cx="3200400" cy="3200400"/>
          </a:xfrm>
          <a:prstGeom prst="rect">
            <a:avLst/>
          </a:prstGeom>
        </p:spPr>
      </p:pic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00E5456E-3E54-4B72-9F07-2936B246B5AC}"/>
              </a:ext>
            </a:extLst>
          </p:cNvPr>
          <p:cNvSpPr txBox="1"/>
          <p:nvPr/>
        </p:nvSpPr>
        <p:spPr>
          <a:xfrm>
            <a:off x="4389120" y="491490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V504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F86D2916-81CB-4A57-89C8-B66827E7C9CF}"/>
              </a:ext>
            </a:extLst>
          </p:cNvPr>
          <p:cNvSpPr txBox="1"/>
          <p:nvPr/>
        </p:nvSpPr>
        <p:spPr>
          <a:xfrm>
            <a:off x="5032634" y="2340804"/>
            <a:ext cx="13385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= 117.231</a:t>
            </a:r>
          </a:p>
        </p:txBody>
      </p:sp>
      <p:grpSp>
        <p:nvGrpSpPr>
          <p:cNvPr id="86" name="Group 85">
            <a:extLst>
              <a:ext uri="{FF2B5EF4-FFF2-40B4-BE49-F238E27FC236}">
                <a16:creationId xmlns:a16="http://schemas.microsoft.com/office/drawing/2014/main" xmlns="" id="{D08FDE85-B684-4AA7-A510-C1368F717170}"/>
              </a:ext>
            </a:extLst>
          </p:cNvPr>
          <p:cNvGrpSpPr/>
          <p:nvPr/>
        </p:nvGrpSpPr>
        <p:grpSpPr>
          <a:xfrm>
            <a:off x="4009074" y="3515315"/>
            <a:ext cx="3200400" cy="3200400"/>
            <a:chOff x="6429688" y="943972"/>
            <a:chExt cx="3200400" cy="3200400"/>
          </a:xfrm>
        </p:grpSpPr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xmlns="" id="{6F986CB5-448C-4960-9190-BEA66CD02A42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006"/>
            <a:stretch/>
          </p:blipFill>
          <p:spPr>
            <a:xfrm>
              <a:off x="6429688" y="943972"/>
              <a:ext cx="3200400" cy="3200400"/>
            </a:xfrm>
            <a:prstGeom prst="rect">
              <a:avLst/>
            </a:prstGeom>
          </p:spPr>
        </p:pic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xmlns="" id="{161F146B-E10E-4F78-B4F9-210227008121}"/>
                </a:ext>
              </a:extLst>
            </p:cNvPr>
            <p:cNvGrpSpPr/>
            <p:nvPr/>
          </p:nvGrpSpPr>
          <p:grpSpPr>
            <a:xfrm>
              <a:off x="7382799" y="1500469"/>
              <a:ext cx="2092204" cy="1725426"/>
              <a:chOff x="7382799" y="1500469"/>
              <a:chExt cx="2092204" cy="1725426"/>
            </a:xfrm>
          </p:grpSpPr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xmlns="" id="{00269159-171E-4D74-83ED-771837BD6784}"/>
                  </a:ext>
                </a:extLst>
              </p:cNvPr>
              <p:cNvSpPr txBox="1"/>
              <p:nvPr/>
            </p:nvSpPr>
            <p:spPr>
              <a:xfrm>
                <a:off x="8602648" y="1500469"/>
                <a:ext cx="8723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V504</a:t>
                </a:r>
              </a:p>
            </p:txBody>
          </p:sp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xmlns="" id="{79D28889-7BF6-43D7-AE6D-5B35A0D26EEC}"/>
                  </a:ext>
                </a:extLst>
              </p:cNvPr>
              <p:cNvSpPr/>
              <p:nvPr/>
            </p:nvSpPr>
            <p:spPr>
              <a:xfrm>
                <a:off x="7382799" y="2918118"/>
                <a:ext cx="134844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C</a:t>
                </a:r>
                <a:r>
                  <a:rPr lang="en-US" sz="14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= 1.79559</a:t>
                </a:r>
              </a:p>
            </p:txBody>
          </p:sp>
        </p:grpSp>
      </p:grpSp>
      <p:pic>
        <p:nvPicPr>
          <p:cNvPr id="91" name="Picture 90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08BDC01C-35DF-4A96-A86A-E062C7399F04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968"/>
          <a:stretch/>
        </p:blipFill>
        <p:spPr>
          <a:xfrm>
            <a:off x="7260230" y="3515315"/>
            <a:ext cx="3200400" cy="3200400"/>
          </a:xfrm>
          <a:prstGeom prst="rect">
            <a:avLst/>
          </a:prstGeom>
        </p:spPr>
      </p:pic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D1BF7E2F-20AF-4A1F-83A3-076EE5E5E01D}"/>
              </a:ext>
            </a:extLst>
          </p:cNvPr>
          <p:cNvSpPr txBox="1"/>
          <p:nvPr/>
        </p:nvSpPr>
        <p:spPr>
          <a:xfrm>
            <a:off x="7609319" y="3536522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2780Cis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846CC3B2-03AC-4036-B8FC-4F130F359835}"/>
              </a:ext>
            </a:extLst>
          </p:cNvPr>
          <p:cNvSpPr txBox="1"/>
          <p:nvPr/>
        </p:nvSpPr>
        <p:spPr>
          <a:xfrm>
            <a:off x="8372103" y="5515031"/>
            <a:ext cx="12490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= 5.1469</a:t>
            </a:r>
          </a:p>
        </p:txBody>
      </p:sp>
      <p:sp>
        <p:nvSpPr>
          <p:cNvPr id="96" name="Slide Number Placeholder 1">
            <a:extLst>
              <a:ext uri="{FF2B5EF4-FFF2-40B4-BE49-F238E27FC236}">
                <a16:creationId xmlns:a16="http://schemas.microsoft.com/office/drawing/2014/main" xmlns="" id="{88476671-55D6-4281-AF49-548BD6D9A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</p:spPr>
        <p:txBody>
          <a:bodyPr/>
          <a:lstStyle/>
          <a:p>
            <a:fld id="{D619523C-807E-43F0-B269-3AFA6A5C2B29}" type="slidenum">
              <a:rPr lang="en-US" smtClean="0"/>
              <a:t>3</a:t>
            </a:fld>
            <a:endParaRPr lang="en-US"/>
          </a:p>
        </p:txBody>
      </p:sp>
      <p:pic>
        <p:nvPicPr>
          <p:cNvPr id="97" name="Picture 96" descr="A close up of a map&#10;&#10;Description automatically generated">
            <a:extLst>
              <a:ext uri="{FF2B5EF4-FFF2-40B4-BE49-F238E27FC236}">
                <a16:creationId xmlns:a16="http://schemas.microsoft.com/office/drawing/2014/main" xmlns="" id="{C84B749C-2A02-46ED-ADA3-D1473679BCB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866"/>
          <a:stretch/>
        </p:blipFill>
        <p:spPr>
          <a:xfrm>
            <a:off x="7443113" y="170340"/>
            <a:ext cx="3685588" cy="3333750"/>
          </a:xfrm>
          <a:prstGeom prst="rect">
            <a:avLst/>
          </a:prstGeom>
        </p:spPr>
      </p:pic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CAC49F3F-7B14-474F-9379-0917EBC9B3D2}"/>
              </a:ext>
            </a:extLst>
          </p:cNvPr>
          <p:cNvSpPr txBox="1"/>
          <p:nvPr/>
        </p:nvSpPr>
        <p:spPr>
          <a:xfrm>
            <a:off x="7910406" y="348097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2780Cis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521B2541-59ED-422B-ABB0-86CDB7E0154A}"/>
              </a:ext>
            </a:extLst>
          </p:cNvPr>
          <p:cNvSpPr txBox="1"/>
          <p:nvPr/>
        </p:nvSpPr>
        <p:spPr>
          <a:xfrm>
            <a:off x="8372103" y="2334312"/>
            <a:ext cx="1149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= 95.53</a:t>
            </a:r>
          </a:p>
        </p:txBody>
      </p:sp>
    </p:spTree>
    <p:extLst>
      <p:ext uri="{BB962C8B-B14F-4D97-AF65-F5344CB8AC3E}">
        <p14:creationId xmlns:p14="http://schemas.microsoft.com/office/powerpoint/2010/main" val="1088325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xmlns="" id="{C9C36D9D-AF84-4BF3-AE07-590E1B90A6A1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598852" y="228600"/>
            <a:ext cx="3200400" cy="32004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B9F1F0C4-2198-4B07-8C34-1B035354436D}"/>
              </a:ext>
            </a:extLst>
          </p:cNvPr>
          <p:cNvSpPr txBox="1"/>
          <p:nvPr/>
        </p:nvSpPr>
        <p:spPr>
          <a:xfrm>
            <a:off x="4825297" y="-25252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S2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xmlns="" id="{F6B2F877-9034-4069-A081-87D4E5F09476}"/>
              </a:ext>
            </a:extLst>
          </p:cNvPr>
          <p:cNvGrpSpPr/>
          <p:nvPr/>
        </p:nvGrpSpPr>
        <p:grpSpPr>
          <a:xfrm>
            <a:off x="261292" y="228600"/>
            <a:ext cx="3200400" cy="3200400"/>
            <a:chOff x="615622" y="3515315"/>
            <a:chExt cx="3200400" cy="3200400"/>
          </a:xfrm>
        </p:grpSpPr>
        <p:pic>
          <p:nvPicPr>
            <p:cNvPr id="24" name="Picture 23" descr="A close up of a map&#10;&#10;Description generated with very high confidence">
              <a:extLst>
                <a:ext uri="{FF2B5EF4-FFF2-40B4-BE49-F238E27FC236}">
                  <a16:creationId xmlns:a16="http://schemas.microsoft.com/office/drawing/2014/main" xmlns="" id="{7655B4DC-9AD0-4552-8C43-F08667C6BB19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405"/>
            <a:stretch/>
          </p:blipFill>
          <p:spPr>
            <a:xfrm>
              <a:off x="615622" y="3515315"/>
              <a:ext cx="3200400" cy="3200400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1A1F6AAF-3CA6-4DAC-8957-C5E413AFFF5F}"/>
                </a:ext>
              </a:extLst>
            </p:cNvPr>
            <p:cNvSpPr txBox="1"/>
            <p:nvPr/>
          </p:nvSpPr>
          <p:spPr>
            <a:xfrm>
              <a:off x="1993281" y="4090824"/>
              <a:ext cx="6925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V-9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F104D48A-D984-450A-B9EF-C4BE25914AE6}"/>
                </a:ext>
              </a:extLst>
            </p:cNvPr>
            <p:cNvSpPr txBox="1"/>
            <p:nvPr/>
          </p:nvSpPr>
          <p:spPr>
            <a:xfrm>
              <a:off x="1993281" y="5571684"/>
              <a:ext cx="13484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= 89.0464</a:t>
              </a:r>
            </a:p>
          </p:txBody>
        </p:sp>
      </p:grpSp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42D37268-040B-4465-871D-C3FBBA447D7D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r="25044"/>
          <a:stretch/>
        </p:blipFill>
        <p:spPr>
          <a:xfrm>
            <a:off x="261292" y="3429000"/>
            <a:ext cx="3200400" cy="320040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2EE788EB-ED54-44FA-BB24-5066D174D955}"/>
              </a:ext>
            </a:extLst>
          </p:cNvPr>
          <p:cNvSpPr txBox="1"/>
          <p:nvPr/>
        </p:nvSpPr>
        <p:spPr>
          <a:xfrm>
            <a:off x="1779921" y="3985459"/>
            <a:ext cx="692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V-9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03DE0507-63E9-469E-A610-6234F08845C9}"/>
              </a:ext>
            </a:extLst>
          </p:cNvPr>
          <p:cNvSpPr txBox="1"/>
          <p:nvPr/>
        </p:nvSpPr>
        <p:spPr>
          <a:xfrm>
            <a:off x="1779921" y="5729209"/>
            <a:ext cx="13484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= 29.3327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xmlns="" id="{64B711DE-8B35-4316-AF04-426D900D10EE}"/>
              </a:ext>
            </a:extLst>
          </p:cNvPr>
          <p:cNvGrpSpPr/>
          <p:nvPr/>
        </p:nvGrpSpPr>
        <p:grpSpPr>
          <a:xfrm>
            <a:off x="3598852" y="3429000"/>
            <a:ext cx="3200400" cy="3200400"/>
            <a:chOff x="6955310" y="692416"/>
            <a:chExt cx="3705776" cy="3333750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xmlns="" id="{4CDFE176-676A-4885-93BB-3E582FF31D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454"/>
            <a:stretch/>
          </p:blipFill>
          <p:spPr>
            <a:xfrm>
              <a:off x="6955310" y="692416"/>
              <a:ext cx="3705776" cy="3333750"/>
            </a:xfrm>
            <a:prstGeom prst="rect">
              <a:avLst/>
            </a:prstGeom>
          </p:spPr>
        </p:pic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xmlns="" id="{C6A508C1-E763-48AB-96AB-88AEA90FEE94}"/>
                </a:ext>
              </a:extLst>
            </p:cNvPr>
            <p:cNvSpPr/>
            <p:nvPr/>
          </p:nvSpPr>
          <p:spPr>
            <a:xfrm>
              <a:off x="7491806" y="895370"/>
              <a:ext cx="1010109" cy="32060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V504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xmlns="" id="{EBC6FD5B-251E-40C1-A9FE-6A1538305955}"/>
                </a:ext>
              </a:extLst>
            </p:cNvPr>
            <p:cNvSpPr/>
            <p:nvPr/>
          </p:nvSpPr>
          <p:spPr>
            <a:xfrm>
              <a:off x="8100043" y="2975163"/>
              <a:ext cx="1561379" cy="32060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= 8.37177</a:t>
              </a:r>
            </a:p>
          </p:txBody>
        </p:sp>
      </p:grpSp>
      <p:pic>
        <p:nvPicPr>
          <p:cNvPr id="35" name="Picture 34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455AD84F-1097-4DB5-93AB-FB09CCEDDF81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544"/>
          <a:stretch/>
        </p:blipFill>
        <p:spPr>
          <a:xfrm>
            <a:off x="7026594" y="228600"/>
            <a:ext cx="3200400" cy="3200400"/>
          </a:xfrm>
          <a:prstGeom prst="rect">
            <a:avLst/>
          </a:prstGeom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xmlns="" id="{D134FA14-B65F-4774-80A2-BC03167374FB}"/>
              </a:ext>
            </a:extLst>
          </p:cNvPr>
          <p:cNvSpPr/>
          <p:nvPr/>
        </p:nvSpPr>
        <p:spPr>
          <a:xfrm>
            <a:off x="8971279" y="773332"/>
            <a:ext cx="110639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920" b="1" i="0" u="none" strike="noStrike" kern="1200" spc="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 dirty="0"/>
              <a:t>A2780Cis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xmlns="" id="{85B6F9C0-747D-4804-A71A-631FC6377BCC}"/>
              </a:ext>
            </a:extLst>
          </p:cNvPr>
          <p:cNvSpPr/>
          <p:nvPr/>
        </p:nvSpPr>
        <p:spPr>
          <a:xfrm>
            <a:off x="8772506" y="2284969"/>
            <a:ext cx="151676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= 81.9158</a:t>
            </a:r>
          </a:p>
        </p:txBody>
      </p:sp>
      <p:pic>
        <p:nvPicPr>
          <p:cNvPr id="38" name="Picture 37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4AD1B257-01D5-44EF-9180-E64A6E387D6D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026"/>
          <a:stretch/>
        </p:blipFill>
        <p:spPr>
          <a:xfrm>
            <a:off x="7026594" y="3429000"/>
            <a:ext cx="3200400" cy="3200400"/>
          </a:xfrm>
          <a:prstGeom prst="rect">
            <a:avLst/>
          </a:prstGeom>
        </p:spPr>
      </p:pic>
      <p:sp>
        <p:nvSpPr>
          <p:cNvPr id="39" name="Rectangle 38">
            <a:extLst>
              <a:ext uri="{FF2B5EF4-FFF2-40B4-BE49-F238E27FC236}">
                <a16:creationId xmlns:a16="http://schemas.microsoft.com/office/drawing/2014/main" xmlns="" id="{85926FAD-3339-4015-9922-0B3FDA3C6FF4}"/>
              </a:ext>
            </a:extLst>
          </p:cNvPr>
          <p:cNvSpPr/>
          <p:nvPr/>
        </p:nvSpPr>
        <p:spPr>
          <a:xfrm>
            <a:off x="9192259" y="4549042"/>
            <a:ext cx="110639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920" b="1" i="0" u="none" strike="noStrike" kern="1200" spc="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600" dirty="0"/>
              <a:t>A2780Ci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91D52D43-E7D6-42BA-962D-78EB00D195BF}"/>
              </a:ext>
            </a:extLst>
          </p:cNvPr>
          <p:cNvSpPr txBox="1"/>
          <p:nvPr/>
        </p:nvSpPr>
        <p:spPr>
          <a:xfrm>
            <a:off x="8342895" y="5558882"/>
            <a:ext cx="13484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= 3.83663</a:t>
            </a:r>
          </a:p>
        </p:txBody>
      </p:sp>
      <p:sp>
        <p:nvSpPr>
          <p:cNvPr id="41" name="Slide Number Placeholder 6">
            <a:extLst>
              <a:ext uri="{FF2B5EF4-FFF2-40B4-BE49-F238E27FC236}">
                <a16:creationId xmlns:a16="http://schemas.microsoft.com/office/drawing/2014/main" xmlns="" id="{EC472A71-FA46-4999-98D5-A7FF5A8EF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</p:spPr>
        <p:txBody>
          <a:bodyPr/>
          <a:lstStyle/>
          <a:p>
            <a:fld id="{D619523C-807E-43F0-B269-3AFA6A5C2B2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4997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1894D174-83B5-4F7F-8FCC-D2F8D13FF271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777201" y="400110"/>
            <a:ext cx="4114800" cy="32004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77C124C5-97D3-4EE8-9F0C-4C88EC58688C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777201" y="3229925"/>
            <a:ext cx="4114800" cy="3200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D14FFE6E-66FB-408C-B61B-9398F9DC953B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212836" y="400110"/>
            <a:ext cx="4114800" cy="3200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954CA113-BFAF-4BEA-9C8B-8CCA73DD40C1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212836" y="3229925"/>
            <a:ext cx="4114800" cy="3200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7B49CBCB-B9BB-47B1-9075-5CE8E38A0CA4}"/>
              </a:ext>
            </a:extLst>
          </p:cNvPr>
          <p:cNvSpPr txBox="1"/>
          <p:nvPr/>
        </p:nvSpPr>
        <p:spPr>
          <a:xfrm>
            <a:off x="4903470" y="0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S3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xmlns="" id="{695B0102-175D-4D5C-ADC2-46ABDA14E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5054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9004D221-5B8D-4904-9799-64B896EC5A26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701952" y="89223"/>
            <a:ext cx="4114800" cy="3200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F5287726-1707-458C-AF02-2A31E70D4DEB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701952" y="2983230"/>
            <a:ext cx="4114800" cy="32004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AFB6A63D-E380-415B-9FCC-A8C4519D5DD1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17748" y="2983230"/>
            <a:ext cx="4114800" cy="32004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0E894021-2F66-44BB-BF32-6B4DA3CA3FAA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17748" y="89223"/>
            <a:ext cx="4114800" cy="3200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61051CD-3D70-42DE-AF7C-109ACD1A99CE}"/>
              </a:ext>
            </a:extLst>
          </p:cNvPr>
          <p:cNvSpPr txBox="1"/>
          <p:nvPr/>
        </p:nvSpPr>
        <p:spPr>
          <a:xfrm>
            <a:off x="4903470" y="0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S3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xmlns="" id="{8C685CB3-B248-4C1A-80BF-595FABA77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4034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3FCFD4E1-E71F-4D31-961A-0704E1766132}"/>
              </a:ext>
            </a:extLst>
          </p:cNvPr>
          <p:cNvGrpSpPr/>
          <p:nvPr/>
        </p:nvGrpSpPr>
        <p:grpSpPr>
          <a:xfrm>
            <a:off x="5048052" y="500244"/>
            <a:ext cx="3200400" cy="3200400"/>
            <a:chOff x="6515611" y="714420"/>
            <a:chExt cx="3729780" cy="333375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16F67B01-BFA7-47C1-A03D-1390CDEF0F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966"/>
            <a:stretch/>
          </p:blipFill>
          <p:spPr>
            <a:xfrm>
              <a:off x="6515611" y="714420"/>
              <a:ext cx="3729780" cy="333375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CD0F6F33-CBF4-4D39-B95A-19C66D4F09C6}"/>
                </a:ext>
              </a:extLst>
            </p:cNvPr>
            <p:cNvSpPr txBox="1"/>
            <p:nvPr/>
          </p:nvSpPr>
          <p:spPr>
            <a:xfrm>
              <a:off x="7158526" y="935586"/>
              <a:ext cx="863462" cy="352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RK2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423D5A4C-B23F-4428-987B-2B0BAD9D85F3}"/>
                </a:ext>
              </a:extLst>
            </p:cNvPr>
            <p:cNvSpPr/>
            <p:nvPr/>
          </p:nvSpPr>
          <p:spPr>
            <a:xfrm>
              <a:off x="7908842" y="2847899"/>
              <a:ext cx="150393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IC</a:t>
              </a:r>
              <a:r>
                <a:rPr lang="en-US" b="1" baseline="-25000" dirty="0"/>
                <a:t>50</a:t>
              </a:r>
              <a:r>
                <a:rPr lang="en-US" b="1" dirty="0"/>
                <a:t> = 57.9664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36259AF4-511D-40CF-AE46-F9FB134812FF}"/>
              </a:ext>
            </a:extLst>
          </p:cNvPr>
          <p:cNvGrpSpPr/>
          <p:nvPr/>
        </p:nvGrpSpPr>
        <p:grpSpPr>
          <a:xfrm>
            <a:off x="5219788" y="3657600"/>
            <a:ext cx="3200400" cy="3200400"/>
            <a:chOff x="6707547" y="591656"/>
            <a:chExt cx="3752298" cy="3411631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061A2010-40D8-4396-A4FD-F574979081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6609"/>
            <a:stretch/>
          </p:blipFill>
          <p:spPr>
            <a:xfrm>
              <a:off x="6707547" y="591656"/>
              <a:ext cx="3752298" cy="3411631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E300BBBA-1DBB-4980-AA1B-BAB3569EFF7E}"/>
                </a:ext>
              </a:extLst>
            </p:cNvPr>
            <p:cNvSpPr txBox="1"/>
            <p:nvPr/>
          </p:nvSpPr>
          <p:spPr>
            <a:xfrm>
              <a:off x="8486228" y="981615"/>
              <a:ext cx="8130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RK2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xmlns="" id="{A1370D37-B059-4E51-8B05-6E13C167EA55}"/>
                </a:ext>
              </a:extLst>
            </p:cNvPr>
            <p:cNvSpPr/>
            <p:nvPr/>
          </p:nvSpPr>
          <p:spPr>
            <a:xfrm>
              <a:off x="8401615" y="2877294"/>
              <a:ext cx="150393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IC</a:t>
              </a:r>
              <a:r>
                <a:rPr lang="en-US" b="1" baseline="-25000" dirty="0"/>
                <a:t>50</a:t>
              </a:r>
              <a:r>
                <a:rPr lang="en-US" b="1" dirty="0"/>
                <a:t> = 0.46381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1D763AE0-A1E0-42AF-8836-2B95453F3E00}"/>
              </a:ext>
            </a:extLst>
          </p:cNvPr>
          <p:cNvGrpSpPr/>
          <p:nvPr/>
        </p:nvGrpSpPr>
        <p:grpSpPr>
          <a:xfrm>
            <a:off x="1574543" y="472697"/>
            <a:ext cx="3200400" cy="3200400"/>
            <a:chOff x="6433919" y="1010248"/>
            <a:chExt cx="3694452" cy="3333750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9DE53E37-D6E9-4DF0-B584-5D823E9576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685"/>
            <a:stretch/>
          </p:blipFill>
          <p:spPr>
            <a:xfrm>
              <a:off x="6433919" y="1010248"/>
              <a:ext cx="3694452" cy="333375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5307B1B4-2629-410D-BFE5-2986EB5937A4}"/>
                </a:ext>
              </a:extLst>
            </p:cNvPr>
            <p:cNvSpPr txBox="1"/>
            <p:nvPr/>
          </p:nvSpPr>
          <p:spPr>
            <a:xfrm>
              <a:off x="7399070" y="1473494"/>
              <a:ext cx="934853" cy="352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RK-1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CB715D9D-A965-4E75-8842-7D4A146AF5E7}"/>
                </a:ext>
              </a:extLst>
            </p:cNvPr>
            <p:cNvSpPr/>
            <p:nvPr/>
          </p:nvSpPr>
          <p:spPr>
            <a:xfrm>
              <a:off x="8129223" y="3189094"/>
              <a:ext cx="1750908" cy="35266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= 134.021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xmlns="" id="{85FA819F-1123-402F-8B59-320845DFA1A3}"/>
              </a:ext>
            </a:extLst>
          </p:cNvPr>
          <p:cNvGrpSpPr/>
          <p:nvPr/>
        </p:nvGrpSpPr>
        <p:grpSpPr>
          <a:xfrm>
            <a:off x="1574543" y="3657600"/>
            <a:ext cx="3200400" cy="3200400"/>
            <a:chOff x="6704316" y="807827"/>
            <a:chExt cx="3674689" cy="3333750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06C0A9E4-525C-4234-AC11-39C2A142FE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088"/>
            <a:stretch/>
          </p:blipFill>
          <p:spPr>
            <a:xfrm>
              <a:off x="6704316" y="807827"/>
              <a:ext cx="3674689" cy="3333750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E41F7D9A-3F06-4B33-A795-83DC56C0F573}"/>
                </a:ext>
              </a:extLst>
            </p:cNvPr>
            <p:cNvSpPr txBox="1"/>
            <p:nvPr/>
          </p:nvSpPr>
          <p:spPr>
            <a:xfrm>
              <a:off x="9055605" y="1126030"/>
              <a:ext cx="8098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RK-1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xmlns="" id="{C742D023-7852-4063-8058-0EAE91CAE0AB}"/>
                </a:ext>
              </a:extLst>
            </p:cNvPr>
            <p:cNvSpPr/>
            <p:nvPr/>
          </p:nvSpPr>
          <p:spPr>
            <a:xfrm>
              <a:off x="8232618" y="3059668"/>
              <a:ext cx="150150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= 0.73211</a:t>
              </a:r>
            </a:p>
          </p:txBody>
        </p:sp>
      </p:grp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50973CF-07F7-4968-9581-A3D6C81DB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7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D5101170-70DF-4D15-B135-BB2B458C469E}"/>
              </a:ext>
            </a:extLst>
          </p:cNvPr>
          <p:cNvSpPr txBox="1"/>
          <p:nvPr/>
        </p:nvSpPr>
        <p:spPr>
          <a:xfrm>
            <a:off x="4979098" y="0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S4</a:t>
            </a:r>
          </a:p>
        </p:txBody>
      </p:sp>
    </p:spTree>
    <p:extLst>
      <p:ext uri="{BB962C8B-B14F-4D97-AF65-F5344CB8AC3E}">
        <p14:creationId xmlns:p14="http://schemas.microsoft.com/office/powerpoint/2010/main" val="26669994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A75053B2-1F8D-4BF1-952F-8E82828546AB}"/>
              </a:ext>
            </a:extLst>
          </p:cNvPr>
          <p:cNvGrpSpPr/>
          <p:nvPr/>
        </p:nvGrpSpPr>
        <p:grpSpPr>
          <a:xfrm>
            <a:off x="4722505" y="305734"/>
            <a:ext cx="3200400" cy="3200400"/>
            <a:chOff x="6464579" y="648774"/>
            <a:chExt cx="3906056" cy="333375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79FA0692-FCCF-40D6-8E55-C9DD35A619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372"/>
            <a:stretch/>
          </p:blipFill>
          <p:spPr>
            <a:xfrm>
              <a:off x="6464579" y="648774"/>
              <a:ext cx="3906056" cy="333375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F41EFFE4-8A70-47D8-9E00-CCCFC2B6B6D4}"/>
                </a:ext>
              </a:extLst>
            </p:cNvPr>
            <p:cNvSpPr txBox="1"/>
            <p:nvPr/>
          </p:nvSpPr>
          <p:spPr>
            <a:xfrm>
              <a:off x="8068793" y="1136578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RK2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F827BAAE-D3CD-441E-A47C-62C0E1A4CA20}"/>
                </a:ext>
              </a:extLst>
            </p:cNvPr>
            <p:cNvSpPr/>
            <p:nvPr/>
          </p:nvSpPr>
          <p:spPr>
            <a:xfrm>
              <a:off x="8020095" y="2814940"/>
              <a:ext cx="150393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IC</a:t>
              </a:r>
              <a:r>
                <a:rPr lang="en-US" b="1" baseline="-25000" dirty="0"/>
                <a:t>50</a:t>
              </a:r>
              <a:r>
                <a:rPr lang="en-US" b="1" dirty="0"/>
                <a:t> = 33.1424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177C446B-409A-4B0B-A76B-5266F5859C50}"/>
              </a:ext>
            </a:extLst>
          </p:cNvPr>
          <p:cNvGrpSpPr/>
          <p:nvPr/>
        </p:nvGrpSpPr>
        <p:grpSpPr>
          <a:xfrm>
            <a:off x="977681" y="3280410"/>
            <a:ext cx="3200400" cy="3200400"/>
            <a:chOff x="6190120" y="803552"/>
            <a:chExt cx="3946339" cy="3333750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xmlns="" id="{E9A236C6-820C-41A8-96C3-EC5D68AAD91F}"/>
                </a:ext>
              </a:extLst>
            </p:cNvPr>
            <p:cNvGrpSpPr/>
            <p:nvPr/>
          </p:nvGrpSpPr>
          <p:grpSpPr>
            <a:xfrm>
              <a:off x="6190120" y="803552"/>
              <a:ext cx="3946339" cy="3333750"/>
              <a:chOff x="6190120" y="803552"/>
              <a:chExt cx="3946339" cy="3333750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xmlns="" id="{ACD7C0C1-702F-4FF2-918E-60B03ABA46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9551"/>
              <a:stretch/>
            </p:blipFill>
            <p:spPr>
              <a:xfrm>
                <a:off x="6190120" y="803552"/>
                <a:ext cx="3946339" cy="3333750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xmlns="" id="{EE0CFA8D-0F19-4126-A145-069CB7BBB6D9}"/>
                  </a:ext>
                </a:extLst>
              </p:cNvPr>
              <p:cNvSpPr txBox="1"/>
              <p:nvPr/>
            </p:nvSpPr>
            <p:spPr>
              <a:xfrm>
                <a:off x="8119149" y="1179512"/>
                <a:ext cx="69762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ARK1</a:t>
                </a:r>
              </a:p>
            </p:txBody>
          </p:sp>
        </p:grp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xmlns="" id="{31195F86-8FEF-4066-BDDE-21F0D3D3D526}"/>
                </a:ext>
              </a:extLst>
            </p:cNvPr>
            <p:cNvSpPr/>
            <p:nvPr/>
          </p:nvSpPr>
          <p:spPr>
            <a:xfrm>
              <a:off x="7894638" y="2785051"/>
              <a:ext cx="1890127" cy="3847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b="1" dirty="0"/>
                <a:t>IC</a:t>
              </a:r>
              <a:r>
                <a:rPr lang="en-US" b="1" baseline="-25000" dirty="0"/>
                <a:t>50</a:t>
              </a:r>
              <a:r>
                <a:rPr lang="en-US" b="1" dirty="0"/>
                <a:t> = 24.5526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6670CCEB-B1BF-4146-BE24-F274DD643542}"/>
              </a:ext>
            </a:extLst>
          </p:cNvPr>
          <p:cNvGrpSpPr/>
          <p:nvPr/>
        </p:nvGrpSpPr>
        <p:grpSpPr>
          <a:xfrm>
            <a:off x="4722505" y="3280410"/>
            <a:ext cx="3200400" cy="3200400"/>
            <a:chOff x="6448426" y="798719"/>
            <a:chExt cx="3586738" cy="3333750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74FDF3CE-E2D4-4DF7-93D6-6D2DEC6FC5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6881"/>
            <a:stretch/>
          </p:blipFill>
          <p:spPr>
            <a:xfrm>
              <a:off x="6448426" y="798719"/>
              <a:ext cx="3586738" cy="333375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D99C99AA-BED0-413A-B8BC-251B357AFF0F}"/>
                </a:ext>
              </a:extLst>
            </p:cNvPr>
            <p:cNvSpPr txBox="1"/>
            <p:nvPr/>
          </p:nvSpPr>
          <p:spPr>
            <a:xfrm>
              <a:off x="8109618" y="1016228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RK2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xmlns="" id="{E17DE7F2-52A7-44B2-AF82-B137603E499D}"/>
                </a:ext>
              </a:extLst>
            </p:cNvPr>
            <p:cNvSpPr/>
            <p:nvPr/>
          </p:nvSpPr>
          <p:spPr>
            <a:xfrm>
              <a:off x="8331905" y="3121671"/>
              <a:ext cx="150874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IC</a:t>
              </a:r>
              <a:r>
                <a:rPr lang="en-US" b="1" baseline="-25000" dirty="0"/>
                <a:t>50</a:t>
              </a:r>
              <a:r>
                <a:rPr lang="en-US" b="1" dirty="0"/>
                <a:t> = 19.3522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63CFFE7F-F34F-4EB2-9AE6-D9EDC1A3B349}"/>
              </a:ext>
            </a:extLst>
          </p:cNvPr>
          <p:cNvGrpSpPr/>
          <p:nvPr/>
        </p:nvGrpSpPr>
        <p:grpSpPr>
          <a:xfrm>
            <a:off x="977681" y="305734"/>
            <a:ext cx="3200400" cy="3200400"/>
            <a:chOff x="5981340" y="655226"/>
            <a:chExt cx="3753676" cy="3333750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248E3DCD-F085-4B2F-B1B2-2D6DEBD327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478"/>
            <a:stretch/>
          </p:blipFill>
          <p:spPr>
            <a:xfrm>
              <a:off x="5981340" y="655226"/>
              <a:ext cx="3753676" cy="333375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8524E05C-0976-4D57-B4F8-2709D22FAEA3}"/>
                </a:ext>
              </a:extLst>
            </p:cNvPr>
            <p:cNvSpPr txBox="1"/>
            <p:nvPr/>
          </p:nvSpPr>
          <p:spPr>
            <a:xfrm>
              <a:off x="6631208" y="874819"/>
              <a:ext cx="868994" cy="352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RK1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xmlns="" id="{4DD4E083-DA51-4BFE-9ABD-27DE3F7AB8A9}"/>
                </a:ext>
              </a:extLst>
            </p:cNvPr>
            <p:cNvSpPr/>
            <p:nvPr/>
          </p:nvSpPr>
          <p:spPr>
            <a:xfrm>
              <a:off x="7669322" y="2708050"/>
              <a:ext cx="1645486" cy="35266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= 69.922</a:t>
              </a:r>
            </a:p>
          </p:txBody>
        </p:sp>
      </p:grp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E90D79A-6CC7-4619-9C02-D783BB730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523C-807E-43F0-B269-3AFA6A5C2B29}" type="slidenum">
              <a:rPr lang="en-US" smtClean="0"/>
              <a:t>8</a:t>
            </a:fld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464C8271-D07A-481E-B247-9B95290AE632}"/>
              </a:ext>
            </a:extLst>
          </p:cNvPr>
          <p:cNvSpPr txBox="1"/>
          <p:nvPr/>
        </p:nvSpPr>
        <p:spPr>
          <a:xfrm>
            <a:off x="4979098" y="0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S4</a:t>
            </a:r>
          </a:p>
        </p:txBody>
      </p:sp>
    </p:spTree>
    <p:extLst>
      <p:ext uri="{BB962C8B-B14F-4D97-AF65-F5344CB8AC3E}">
        <p14:creationId xmlns:p14="http://schemas.microsoft.com/office/powerpoint/2010/main" val="21185203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xmlns="" id="{B504ACA4-8A25-4470-9F09-908CAE0049B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348"/>
          <a:stretch/>
        </p:blipFill>
        <p:spPr>
          <a:xfrm>
            <a:off x="3928905" y="1202375"/>
            <a:ext cx="3760040" cy="3333750"/>
          </a:xfrm>
          <a:prstGeom prst="rect">
            <a:avLst/>
          </a:prstGeom>
        </p:spPr>
      </p:pic>
      <p:pic>
        <p:nvPicPr>
          <p:cNvPr id="8" name="Picture 7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36A7E6CC-B1FF-4AEC-A1D1-5723FCEA740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580"/>
          <a:stretch/>
        </p:blipFill>
        <p:spPr>
          <a:xfrm>
            <a:off x="327356" y="1202375"/>
            <a:ext cx="3601549" cy="3333750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2278E498-7A48-41E9-8EEF-3A1D3E72F3CC}"/>
              </a:ext>
            </a:extLst>
          </p:cNvPr>
          <p:cNvGrpSpPr/>
          <p:nvPr/>
        </p:nvGrpSpPr>
        <p:grpSpPr>
          <a:xfrm>
            <a:off x="894451" y="2313361"/>
            <a:ext cx="1110497" cy="740554"/>
            <a:chOff x="1095418" y="2454038"/>
            <a:chExt cx="1110497" cy="74055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675D0293-533A-4244-B6CB-2FFB68F95D6A}"/>
                </a:ext>
              </a:extLst>
            </p:cNvPr>
            <p:cNvSpPr txBox="1"/>
            <p:nvPr/>
          </p:nvSpPr>
          <p:spPr>
            <a:xfrm>
              <a:off x="1095418" y="2886815"/>
              <a:ext cx="982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ynergistic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4A20547D-7742-46B3-AFB0-A23D18A868A0}"/>
                </a:ext>
              </a:extLst>
            </p:cNvPr>
            <p:cNvSpPr txBox="1"/>
            <p:nvPr/>
          </p:nvSpPr>
          <p:spPr>
            <a:xfrm>
              <a:off x="1095418" y="2454038"/>
              <a:ext cx="11104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ntagonistic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A475E1B-BCB8-4DC3-A413-7E6F4FF4DC52}"/>
              </a:ext>
            </a:extLst>
          </p:cNvPr>
          <p:cNvSpPr txBox="1"/>
          <p:nvPr/>
        </p:nvSpPr>
        <p:spPr>
          <a:xfrm>
            <a:off x="1527349" y="1202375"/>
            <a:ext cx="699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V9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525FB77-04E2-4C15-95C7-56CA5639F7C9}"/>
              </a:ext>
            </a:extLst>
          </p:cNvPr>
          <p:cNvSpPr txBox="1"/>
          <p:nvPr/>
        </p:nvSpPr>
        <p:spPr>
          <a:xfrm>
            <a:off x="4533116" y="1263034"/>
            <a:ext cx="9380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V504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387F4595-0523-42E5-9DF2-C045BD837102}"/>
              </a:ext>
            </a:extLst>
          </p:cNvPr>
          <p:cNvGrpSpPr/>
          <p:nvPr/>
        </p:nvGrpSpPr>
        <p:grpSpPr>
          <a:xfrm>
            <a:off x="5277216" y="2465761"/>
            <a:ext cx="1110497" cy="740554"/>
            <a:chOff x="1095418" y="2454038"/>
            <a:chExt cx="1110497" cy="740554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3C2B8B89-3D49-4C1C-8BCD-2D7476E20034}"/>
                </a:ext>
              </a:extLst>
            </p:cNvPr>
            <p:cNvSpPr txBox="1"/>
            <p:nvPr/>
          </p:nvSpPr>
          <p:spPr>
            <a:xfrm>
              <a:off x="1095418" y="2886815"/>
              <a:ext cx="982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ynergistic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BFA2A912-0743-449F-9C58-8C4CC52FB8C4}"/>
                </a:ext>
              </a:extLst>
            </p:cNvPr>
            <p:cNvSpPr txBox="1"/>
            <p:nvPr/>
          </p:nvSpPr>
          <p:spPr>
            <a:xfrm>
              <a:off x="1095418" y="2454038"/>
              <a:ext cx="11104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ntagonistic</a:t>
              </a:r>
            </a:p>
          </p:txBody>
        </p:sp>
      </p:grpSp>
      <p:sp>
        <p:nvSpPr>
          <p:cNvPr id="17" name="Slide Number Placeholder 16">
            <a:extLst>
              <a:ext uri="{FF2B5EF4-FFF2-40B4-BE49-F238E27FC236}">
                <a16:creationId xmlns:a16="http://schemas.microsoft.com/office/drawing/2014/main" xmlns="" id="{280CF0C1-5CE4-4D34-8ECF-E08329A75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1F32F-4605-40C6-88EA-D0BD97672771}" type="slidenum">
              <a:rPr lang="en-US" smtClean="0"/>
              <a:t>9</a:t>
            </a:fld>
            <a:endParaRPr lang="en-US"/>
          </a:p>
        </p:txBody>
      </p:sp>
      <p:pic>
        <p:nvPicPr>
          <p:cNvPr id="21" name="Picture 20" descr="A close up of a map&#10;&#10;Description generated with very high confidence">
            <a:extLst>
              <a:ext uri="{FF2B5EF4-FFF2-40B4-BE49-F238E27FC236}">
                <a16:creationId xmlns:a16="http://schemas.microsoft.com/office/drawing/2014/main" xmlns="" id="{9D48B3E4-A34C-4C02-81F1-AB115A47350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580"/>
          <a:stretch/>
        </p:blipFill>
        <p:spPr>
          <a:xfrm>
            <a:off x="7608232" y="1231663"/>
            <a:ext cx="3601550" cy="3333750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xmlns="" id="{143D67BB-79D5-4048-9760-A9C035199873}"/>
              </a:ext>
            </a:extLst>
          </p:cNvPr>
          <p:cNvGrpSpPr/>
          <p:nvPr/>
        </p:nvGrpSpPr>
        <p:grpSpPr>
          <a:xfrm>
            <a:off x="8338866" y="2465761"/>
            <a:ext cx="1110497" cy="740554"/>
            <a:chOff x="1095418" y="2454038"/>
            <a:chExt cx="1110497" cy="740554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19855CEE-F2C1-40A9-A926-4751CB8E4A64}"/>
                </a:ext>
              </a:extLst>
            </p:cNvPr>
            <p:cNvSpPr txBox="1"/>
            <p:nvPr/>
          </p:nvSpPr>
          <p:spPr>
            <a:xfrm>
              <a:off x="1095418" y="2886815"/>
              <a:ext cx="9827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ynergistic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0799CF43-0576-4B01-AECE-FF03BC265871}"/>
                </a:ext>
              </a:extLst>
            </p:cNvPr>
            <p:cNvSpPr txBox="1"/>
            <p:nvPr/>
          </p:nvSpPr>
          <p:spPr>
            <a:xfrm>
              <a:off x="1095418" y="2454038"/>
              <a:ext cx="11104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ntagonistic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6BF6606A-995E-44A1-8EED-04B9830790DC}"/>
              </a:ext>
            </a:extLst>
          </p:cNvPr>
          <p:cNvSpPr txBox="1"/>
          <p:nvPr/>
        </p:nvSpPr>
        <p:spPr>
          <a:xfrm>
            <a:off x="8084654" y="1479380"/>
            <a:ext cx="1051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2780Ci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E3BDE594-F19E-4B02-8B38-C1154129E38D}"/>
              </a:ext>
            </a:extLst>
          </p:cNvPr>
          <p:cNvSpPr txBox="1"/>
          <p:nvPr/>
        </p:nvSpPr>
        <p:spPr>
          <a:xfrm>
            <a:off x="4325295" y="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FE722778-514F-4660-A9FD-3DFFF0D97BD2}"/>
              </a:ext>
            </a:extLst>
          </p:cNvPr>
          <p:cNvSpPr txBox="1"/>
          <p:nvPr/>
        </p:nvSpPr>
        <p:spPr>
          <a:xfrm>
            <a:off x="327356" y="100483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332233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5</TotalTime>
  <Words>249</Words>
  <Application>Microsoft Office PowerPoint</Application>
  <PresentationFormat>Custom</PresentationFormat>
  <Paragraphs>124</Paragraphs>
  <Slides>14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6" baseType="lpstr">
      <vt:lpstr>Office Theme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kata Dasari</dc:creator>
  <cp:lastModifiedBy>Sevilla, Hernando Jr.</cp:lastModifiedBy>
  <cp:revision>52</cp:revision>
  <dcterms:created xsi:type="dcterms:W3CDTF">2018-12-06T18:28:14Z</dcterms:created>
  <dcterms:modified xsi:type="dcterms:W3CDTF">2020-03-30T02:44:04Z</dcterms:modified>
</cp:coreProperties>
</file>